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0"/>
  </p:normalViewPr>
  <p:slideViewPr>
    <p:cSldViewPr snapToGrid="0" snapToObjects="1">
      <p:cViewPr varScale="1">
        <p:scale>
          <a:sx n="115" d="100"/>
          <a:sy n="115" d="100"/>
        </p:scale>
        <p:origin x="4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83D997-B195-4B49-9AAF-AB14FDB43057}" type="datetimeFigureOut">
              <a:rPr lang="en-US" smtClean="0"/>
              <a:t>9/26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B88619-C3F5-424F-AF9F-B5FBF8BE2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51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10631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002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67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62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87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798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557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506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37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784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448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210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33E28-C713-B24B-9B3E-8B29662AAA04}" type="datetimeFigureOut">
              <a:rPr lang="en-US" smtClean="0"/>
              <a:t>9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858A6-D50D-9740-B94B-292842EBC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674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tiff"/><Relationship Id="rId5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007793" y="589897"/>
            <a:ext cx="8971817" cy="5758360"/>
            <a:chOff x="662105" y="835224"/>
            <a:chExt cx="8971817" cy="5758360"/>
          </a:xfrm>
        </p:grpSpPr>
        <p:sp>
          <p:nvSpPr>
            <p:cNvPr id="4" name="TextBox 3"/>
            <p:cNvSpPr txBox="1"/>
            <p:nvPr/>
          </p:nvSpPr>
          <p:spPr>
            <a:xfrm>
              <a:off x="4419601" y="1447800"/>
              <a:ext cx="1979773" cy="3693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b="1" dirty="0" smtClean="0">
                  <a:solidFill>
                    <a:srgbClr val="000000"/>
                  </a:solidFill>
                </a:rPr>
                <a:t>Human </a:t>
              </a:r>
              <a:r>
                <a:rPr lang="en-US" b="1" dirty="0">
                  <a:solidFill>
                    <a:srgbClr val="000000"/>
                  </a:solidFill>
                </a:rPr>
                <a:t>monocytes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471429" y="2004558"/>
              <a:ext cx="591957" cy="30777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1400" dirty="0" smtClean="0">
                  <a:solidFill>
                    <a:srgbClr val="000000"/>
                  </a:solidFill>
                </a:rPr>
                <a:t>48hrs</a:t>
              </a:r>
              <a:endParaRPr lang="en-US" sz="1400" dirty="0">
                <a:solidFill>
                  <a:srgbClr val="000000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714142" y="3325115"/>
              <a:ext cx="2618217" cy="369332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b="1" dirty="0" smtClean="0">
                  <a:solidFill>
                    <a:srgbClr val="000000"/>
                  </a:solidFill>
                </a:rPr>
                <a:t>  </a:t>
              </a:r>
              <a:r>
                <a:rPr lang="en-US" b="1" dirty="0">
                  <a:solidFill>
                    <a:srgbClr val="000000"/>
                  </a:solidFill>
                </a:rPr>
                <a:t>CD45</a:t>
              </a:r>
              <a:r>
                <a:rPr lang="en-US" b="1" baseline="30000" dirty="0" smtClean="0">
                  <a:solidFill>
                    <a:srgbClr val="000000"/>
                  </a:solidFill>
                </a:rPr>
                <a:t>+ </a:t>
              </a:r>
              <a:r>
                <a:rPr lang="en-US" b="1" dirty="0" smtClean="0">
                  <a:solidFill>
                    <a:srgbClr val="000000"/>
                  </a:solidFill>
                </a:rPr>
                <a:t>monocytes sorted</a:t>
              </a:r>
              <a:endParaRPr lang="en-US" b="1" dirty="0">
                <a:solidFill>
                  <a:srgbClr val="000000"/>
                </a:solidFill>
              </a:endParaRPr>
            </a:p>
          </p:txBody>
        </p:sp>
        <p:grpSp>
          <p:nvGrpSpPr>
            <p:cNvPr id="7" name="Group 6"/>
            <p:cNvGrpSpPr>
              <a:grpSpLocks/>
            </p:cNvGrpSpPr>
            <p:nvPr/>
          </p:nvGrpSpPr>
          <p:grpSpPr bwMode="auto">
            <a:xfrm>
              <a:off x="4953000" y="838201"/>
              <a:ext cx="857250" cy="674687"/>
              <a:chOff x="2308933" y="748575"/>
              <a:chExt cx="845851" cy="845852"/>
            </a:xfrm>
          </p:grpSpPr>
          <p:sp>
            <p:nvSpPr>
              <p:cNvPr id="25894" name="Freeform 35"/>
              <p:cNvSpPr>
                <a:spLocks noChangeAspect="1"/>
              </p:cNvSpPr>
              <p:nvPr/>
            </p:nvSpPr>
            <p:spPr bwMode="auto">
              <a:xfrm>
                <a:off x="2308933" y="748575"/>
                <a:ext cx="845851" cy="845852"/>
              </a:xfrm>
              <a:custGeom>
                <a:avLst/>
                <a:gdLst>
                  <a:gd name="T0" fmla="*/ 2147483647 w 187"/>
                  <a:gd name="T1" fmla="*/ 2147483647 h 187"/>
                  <a:gd name="T2" fmla="*/ 2147483647 w 187"/>
                  <a:gd name="T3" fmla="*/ 2147483647 h 187"/>
                  <a:gd name="T4" fmla="*/ 2147483647 w 187"/>
                  <a:gd name="T5" fmla="*/ 2147483647 h 187"/>
                  <a:gd name="T6" fmla="*/ 2147483647 w 187"/>
                  <a:gd name="T7" fmla="*/ 2147483647 h 187"/>
                  <a:gd name="T8" fmla="*/ 2147483647 w 187"/>
                  <a:gd name="T9" fmla="*/ 2147483647 h 187"/>
                  <a:gd name="T10" fmla="*/ 2147483647 w 187"/>
                  <a:gd name="T11" fmla="*/ 2147483647 h 187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87" h="187">
                    <a:moveTo>
                      <a:pt x="13" y="114"/>
                    </a:moveTo>
                    <a:cubicBezTo>
                      <a:pt x="20" y="139"/>
                      <a:pt x="38" y="156"/>
                      <a:pt x="55" y="164"/>
                    </a:cubicBezTo>
                    <a:cubicBezTo>
                      <a:pt x="78" y="175"/>
                      <a:pt x="146" y="187"/>
                      <a:pt x="167" y="123"/>
                    </a:cubicBezTo>
                    <a:cubicBezTo>
                      <a:pt x="187" y="56"/>
                      <a:pt x="143" y="18"/>
                      <a:pt x="119" y="10"/>
                    </a:cubicBezTo>
                    <a:cubicBezTo>
                      <a:pt x="89" y="0"/>
                      <a:pt x="58" y="4"/>
                      <a:pt x="37" y="24"/>
                    </a:cubicBezTo>
                    <a:cubicBezTo>
                      <a:pt x="17" y="42"/>
                      <a:pt x="0" y="68"/>
                      <a:pt x="13" y="114"/>
                    </a:cubicBezTo>
                  </a:path>
                </a:pathLst>
              </a:custGeom>
              <a:solidFill>
                <a:srgbClr val="CCCCFF"/>
              </a:solidFill>
              <a:ln w="9525">
                <a:solidFill>
                  <a:srgbClr val="CC99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5" name="Freeform 36"/>
              <p:cNvSpPr>
                <a:spLocks noChangeAspect="1"/>
              </p:cNvSpPr>
              <p:nvPr/>
            </p:nvSpPr>
            <p:spPr bwMode="auto">
              <a:xfrm>
                <a:off x="2311283" y="1042669"/>
                <a:ext cx="823228" cy="483890"/>
              </a:xfrm>
              <a:custGeom>
                <a:avLst/>
                <a:gdLst>
                  <a:gd name="T0" fmla="*/ 2147483647 w 364"/>
                  <a:gd name="T1" fmla="*/ 2147483647 h 214"/>
                  <a:gd name="T2" fmla="*/ 2147483647 w 364"/>
                  <a:gd name="T3" fmla="*/ 2147483647 h 214"/>
                  <a:gd name="T4" fmla="*/ 2147483647 w 364"/>
                  <a:gd name="T5" fmla="*/ 2147483647 h 214"/>
                  <a:gd name="T6" fmla="*/ 2147483647 w 364"/>
                  <a:gd name="T7" fmla="*/ 2147483647 h 214"/>
                  <a:gd name="T8" fmla="*/ 2147483647 w 364"/>
                  <a:gd name="T9" fmla="*/ 2147483647 h 2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214">
                    <a:moveTo>
                      <a:pt x="187" y="210"/>
                    </a:moveTo>
                    <a:cubicBezTo>
                      <a:pt x="307" y="206"/>
                      <a:pt x="364" y="91"/>
                      <a:pt x="324" y="47"/>
                    </a:cubicBezTo>
                    <a:cubicBezTo>
                      <a:pt x="283" y="3"/>
                      <a:pt x="256" y="70"/>
                      <a:pt x="177" y="78"/>
                    </a:cubicBezTo>
                    <a:cubicBezTo>
                      <a:pt x="99" y="86"/>
                      <a:pt x="92" y="0"/>
                      <a:pt x="46" y="48"/>
                    </a:cubicBezTo>
                    <a:cubicBezTo>
                      <a:pt x="0" y="96"/>
                      <a:pt x="67" y="214"/>
                      <a:pt x="187" y="210"/>
                    </a:cubicBezTo>
                    <a:close/>
                  </a:path>
                </a:pathLst>
              </a:custGeom>
              <a:solidFill>
                <a:srgbClr val="A34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71" name="Oval 41"/>
              <p:cNvSpPr>
                <a:spLocks noChangeAspect="1" noChangeArrowheads="1"/>
              </p:cNvSpPr>
              <p:nvPr/>
            </p:nvSpPr>
            <p:spPr bwMode="auto">
              <a:xfrm>
                <a:off x="2583052" y="1130701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2" name="Oval 42"/>
              <p:cNvSpPr>
                <a:spLocks noChangeAspect="1" noChangeArrowheads="1"/>
              </p:cNvSpPr>
              <p:nvPr/>
            </p:nvSpPr>
            <p:spPr bwMode="auto">
              <a:xfrm>
                <a:off x="2506298" y="1045120"/>
                <a:ext cx="51691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3" name="Oval 43"/>
              <p:cNvSpPr>
                <a:spLocks noChangeAspect="1" noChangeArrowheads="1"/>
              </p:cNvSpPr>
              <p:nvPr/>
            </p:nvSpPr>
            <p:spPr bwMode="auto">
              <a:xfrm>
                <a:off x="2379421" y="1059053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4" name="Oval 45"/>
              <p:cNvSpPr>
                <a:spLocks noChangeAspect="1" noChangeArrowheads="1"/>
              </p:cNvSpPr>
              <p:nvPr/>
            </p:nvSpPr>
            <p:spPr bwMode="auto">
              <a:xfrm>
                <a:off x="2915127" y="931677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5" name="Oval 47"/>
              <p:cNvSpPr>
                <a:spLocks noChangeAspect="1" noChangeArrowheads="1"/>
              </p:cNvSpPr>
              <p:nvPr/>
            </p:nvSpPr>
            <p:spPr bwMode="auto">
              <a:xfrm>
                <a:off x="2634742" y="1074975"/>
                <a:ext cx="51691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6" name="Oval 48"/>
              <p:cNvSpPr>
                <a:spLocks noChangeAspect="1" noChangeArrowheads="1"/>
              </p:cNvSpPr>
              <p:nvPr/>
            </p:nvSpPr>
            <p:spPr bwMode="auto">
              <a:xfrm>
                <a:off x="2742824" y="1074975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7" name="Oval 49"/>
              <p:cNvSpPr>
                <a:spLocks noChangeAspect="1" noChangeArrowheads="1"/>
              </p:cNvSpPr>
              <p:nvPr/>
            </p:nvSpPr>
            <p:spPr bwMode="auto">
              <a:xfrm>
                <a:off x="2799214" y="856048"/>
                <a:ext cx="51690" cy="5373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8" name="Oval 50"/>
              <p:cNvSpPr>
                <a:spLocks noChangeAspect="1" noChangeArrowheads="1"/>
              </p:cNvSpPr>
              <p:nvPr/>
            </p:nvSpPr>
            <p:spPr bwMode="auto">
              <a:xfrm>
                <a:off x="2691132" y="965511"/>
                <a:ext cx="51691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79" name="Oval 51"/>
              <p:cNvSpPr>
                <a:spLocks noChangeAspect="1" noChangeArrowheads="1"/>
              </p:cNvSpPr>
              <p:nvPr/>
            </p:nvSpPr>
            <p:spPr bwMode="auto">
              <a:xfrm>
                <a:off x="2583052" y="856048"/>
                <a:ext cx="51690" cy="5373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80" name="Oval 52"/>
              <p:cNvSpPr>
                <a:spLocks noChangeAspect="1" noChangeArrowheads="1"/>
              </p:cNvSpPr>
              <p:nvPr/>
            </p:nvSpPr>
            <p:spPr bwMode="auto">
              <a:xfrm>
                <a:off x="2691132" y="856048"/>
                <a:ext cx="51691" cy="5373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81" name="Oval 53"/>
              <p:cNvSpPr>
                <a:spLocks noChangeAspect="1" noChangeArrowheads="1"/>
              </p:cNvSpPr>
              <p:nvPr/>
            </p:nvSpPr>
            <p:spPr bwMode="auto">
              <a:xfrm>
                <a:off x="2915127" y="1029198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82" name="Oval 54"/>
              <p:cNvSpPr>
                <a:spLocks noChangeAspect="1" noChangeArrowheads="1"/>
              </p:cNvSpPr>
              <p:nvPr/>
            </p:nvSpPr>
            <p:spPr bwMode="auto">
              <a:xfrm>
                <a:off x="2830542" y="1072984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83" name="Oval 55"/>
              <p:cNvSpPr>
                <a:spLocks noChangeAspect="1" noChangeArrowheads="1"/>
              </p:cNvSpPr>
              <p:nvPr/>
            </p:nvSpPr>
            <p:spPr bwMode="auto">
              <a:xfrm>
                <a:off x="2634742" y="965511"/>
                <a:ext cx="51691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84" name="Oval 56"/>
              <p:cNvSpPr>
                <a:spLocks noChangeAspect="1" noChangeArrowheads="1"/>
              </p:cNvSpPr>
              <p:nvPr/>
            </p:nvSpPr>
            <p:spPr bwMode="auto">
              <a:xfrm>
                <a:off x="2802347" y="959541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  <p:sp>
            <p:nvSpPr>
              <p:cNvPr id="385" name="Oval 62"/>
              <p:cNvSpPr>
                <a:spLocks noChangeAspect="1" noChangeArrowheads="1"/>
              </p:cNvSpPr>
              <p:nvPr/>
            </p:nvSpPr>
            <p:spPr bwMode="auto">
              <a:xfrm>
                <a:off x="2482803" y="965511"/>
                <a:ext cx="51690" cy="51746"/>
              </a:xfrm>
              <a:prstGeom prst="ellipse">
                <a:avLst/>
              </a:prstGeom>
              <a:solidFill>
                <a:srgbClr val="333333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367" name="Freeform 11"/>
            <p:cNvSpPr>
              <a:spLocks noChangeAspect="1"/>
            </p:cNvSpPr>
            <p:nvPr/>
          </p:nvSpPr>
          <p:spPr bwMode="auto">
            <a:xfrm>
              <a:off x="6400800" y="914401"/>
              <a:ext cx="916966" cy="596887"/>
            </a:xfrm>
            <a:custGeom>
              <a:avLst/>
              <a:gdLst>
                <a:gd name="T0" fmla="*/ 619 w 619"/>
                <a:gd name="T1" fmla="*/ 167 h 613"/>
                <a:gd name="T2" fmla="*/ 520 w 619"/>
                <a:gd name="T3" fmla="*/ 133 h 613"/>
                <a:gd name="T4" fmla="*/ 375 w 619"/>
                <a:gd name="T5" fmla="*/ 251 h 613"/>
                <a:gd name="T6" fmla="*/ 368 w 619"/>
                <a:gd name="T7" fmla="*/ 289 h 613"/>
                <a:gd name="T8" fmla="*/ 524 w 619"/>
                <a:gd name="T9" fmla="*/ 361 h 613"/>
                <a:gd name="T10" fmla="*/ 440 w 619"/>
                <a:gd name="T11" fmla="*/ 333 h 613"/>
                <a:gd name="T12" fmla="*/ 528 w 619"/>
                <a:gd name="T13" fmla="*/ 469 h 613"/>
                <a:gd name="T14" fmla="*/ 356 w 619"/>
                <a:gd name="T15" fmla="*/ 301 h 613"/>
                <a:gd name="T16" fmla="*/ 412 w 619"/>
                <a:gd name="T17" fmla="*/ 457 h 613"/>
                <a:gd name="T18" fmla="*/ 536 w 619"/>
                <a:gd name="T19" fmla="*/ 557 h 613"/>
                <a:gd name="T20" fmla="*/ 392 w 619"/>
                <a:gd name="T21" fmla="*/ 437 h 613"/>
                <a:gd name="T22" fmla="*/ 396 w 619"/>
                <a:gd name="T23" fmla="*/ 561 h 613"/>
                <a:gd name="T24" fmla="*/ 375 w 619"/>
                <a:gd name="T25" fmla="*/ 413 h 613"/>
                <a:gd name="T26" fmla="*/ 348 w 619"/>
                <a:gd name="T27" fmla="*/ 301 h 613"/>
                <a:gd name="T28" fmla="*/ 304 w 619"/>
                <a:gd name="T29" fmla="*/ 421 h 613"/>
                <a:gd name="T30" fmla="*/ 236 w 619"/>
                <a:gd name="T31" fmla="*/ 481 h 613"/>
                <a:gd name="T32" fmla="*/ 212 w 619"/>
                <a:gd name="T33" fmla="*/ 589 h 613"/>
                <a:gd name="T34" fmla="*/ 212 w 619"/>
                <a:gd name="T35" fmla="*/ 549 h 613"/>
                <a:gd name="T36" fmla="*/ 180 w 619"/>
                <a:gd name="T37" fmla="*/ 613 h 613"/>
                <a:gd name="T38" fmla="*/ 228 w 619"/>
                <a:gd name="T39" fmla="*/ 477 h 613"/>
                <a:gd name="T40" fmla="*/ 332 w 619"/>
                <a:gd name="T41" fmla="*/ 305 h 613"/>
                <a:gd name="T42" fmla="*/ 212 w 619"/>
                <a:gd name="T43" fmla="*/ 409 h 613"/>
                <a:gd name="T44" fmla="*/ 240 w 619"/>
                <a:gd name="T45" fmla="*/ 405 h 613"/>
                <a:gd name="T46" fmla="*/ 228 w 619"/>
                <a:gd name="T47" fmla="*/ 373 h 613"/>
                <a:gd name="T48" fmla="*/ 300 w 619"/>
                <a:gd name="T49" fmla="*/ 269 h 613"/>
                <a:gd name="T50" fmla="*/ 164 w 619"/>
                <a:gd name="T51" fmla="*/ 297 h 613"/>
                <a:gd name="T52" fmla="*/ 296 w 619"/>
                <a:gd name="T53" fmla="*/ 261 h 613"/>
                <a:gd name="T54" fmla="*/ 0 w 619"/>
                <a:gd name="T55" fmla="*/ 265 h 613"/>
                <a:gd name="T56" fmla="*/ 272 w 619"/>
                <a:gd name="T57" fmla="*/ 241 h 613"/>
                <a:gd name="T58" fmla="*/ 168 w 619"/>
                <a:gd name="T59" fmla="*/ 161 h 613"/>
                <a:gd name="T60" fmla="*/ 68 w 619"/>
                <a:gd name="T61" fmla="*/ 193 h 613"/>
                <a:gd name="T62" fmla="*/ 112 w 619"/>
                <a:gd name="T63" fmla="*/ 165 h 613"/>
                <a:gd name="T64" fmla="*/ 16 w 619"/>
                <a:gd name="T65" fmla="*/ 181 h 613"/>
                <a:gd name="T66" fmla="*/ 76 w 619"/>
                <a:gd name="T67" fmla="*/ 161 h 613"/>
                <a:gd name="T68" fmla="*/ 44 w 619"/>
                <a:gd name="T69" fmla="*/ 141 h 613"/>
                <a:gd name="T70" fmla="*/ 168 w 619"/>
                <a:gd name="T71" fmla="*/ 153 h 613"/>
                <a:gd name="T72" fmla="*/ 304 w 619"/>
                <a:gd name="T73" fmla="*/ 245 h 613"/>
                <a:gd name="T74" fmla="*/ 284 w 619"/>
                <a:gd name="T75" fmla="*/ 53 h 613"/>
                <a:gd name="T76" fmla="*/ 376 w 619"/>
                <a:gd name="T77" fmla="*/ 213 h 613"/>
                <a:gd name="T78" fmla="*/ 554 w 619"/>
                <a:gd name="T79" fmla="*/ 0 h 613"/>
                <a:gd name="T80" fmla="*/ 548 w 619"/>
                <a:gd name="T81" fmla="*/ 55 h 613"/>
                <a:gd name="T82" fmla="*/ 576 w 619"/>
                <a:gd name="T83" fmla="*/ 65 h 613"/>
                <a:gd name="T84" fmla="*/ 500 w 619"/>
                <a:gd name="T85" fmla="*/ 129 h 613"/>
                <a:gd name="T86" fmla="*/ 584 w 619"/>
                <a:gd name="T87" fmla="*/ 141 h 613"/>
                <a:gd name="T88" fmla="*/ 619 w 619"/>
                <a:gd name="T89" fmla="*/ 167 h 6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619" h="613">
                  <a:moveTo>
                    <a:pt x="619" y="167"/>
                  </a:moveTo>
                  <a:cubicBezTo>
                    <a:pt x="585" y="148"/>
                    <a:pt x="543" y="130"/>
                    <a:pt x="520" y="133"/>
                  </a:cubicBezTo>
                  <a:cubicBezTo>
                    <a:pt x="472" y="138"/>
                    <a:pt x="371" y="229"/>
                    <a:pt x="375" y="251"/>
                  </a:cubicBezTo>
                  <a:cubicBezTo>
                    <a:pt x="378" y="269"/>
                    <a:pt x="375" y="277"/>
                    <a:pt x="368" y="289"/>
                  </a:cubicBezTo>
                  <a:cubicBezTo>
                    <a:pt x="393" y="327"/>
                    <a:pt x="489" y="313"/>
                    <a:pt x="524" y="361"/>
                  </a:cubicBezTo>
                  <a:cubicBezTo>
                    <a:pt x="501" y="363"/>
                    <a:pt x="476" y="332"/>
                    <a:pt x="440" y="333"/>
                  </a:cubicBezTo>
                  <a:cubicBezTo>
                    <a:pt x="459" y="373"/>
                    <a:pt x="518" y="407"/>
                    <a:pt x="528" y="469"/>
                  </a:cubicBezTo>
                  <a:cubicBezTo>
                    <a:pt x="487" y="397"/>
                    <a:pt x="436" y="334"/>
                    <a:pt x="356" y="301"/>
                  </a:cubicBezTo>
                  <a:cubicBezTo>
                    <a:pt x="375" y="362"/>
                    <a:pt x="381" y="415"/>
                    <a:pt x="412" y="457"/>
                  </a:cubicBezTo>
                  <a:cubicBezTo>
                    <a:pt x="446" y="504"/>
                    <a:pt x="509" y="503"/>
                    <a:pt x="536" y="557"/>
                  </a:cubicBezTo>
                  <a:cubicBezTo>
                    <a:pt x="494" y="511"/>
                    <a:pt x="412" y="505"/>
                    <a:pt x="392" y="437"/>
                  </a:cubicBezTo>
                  <a:cubicBezTo>
                    <a:pt x="372" y="468"/>
                    <a:pt x="379" y="533"/>
                    <a:pt x="396" y="561"/>
                  </a:cubicBezTo>
                  <a:cubicBezTo>
                    <a:pt x="349" y="530"/>
                    <a:pt x="379" y="464"/>
                    <a:pt x="375" y="413"/>
                  </a:cubicBezTo>
                  <a:cubicBezTo>
                    <a:pt x="371" y="369"/>
                    <a:pt x="348" y="339"/>
                    <a:pt x="348" y="301"/>
                  </a:cubicBezTo>
                  <a:cubicBezTo>
                    <a:pt x="339" y="360"/>
                    <a:pt x="344" y="379"/>
                    <a:pt x="304" y="421"/>
                  </a:cubicBezTo>
                  <a:cubicBezTo>
                    <a:pt x="284" y="442"/>
                    <a:pt x="253" y="456"/>
                    <a:pt x="236" y="481"/>
                  </a:cubicBezTo>
                  <a:cubicBezTo>
                    <a:pt x="216" y="511"/>
                    <a:pt x="227" y="549"/>
                    <a:pt x="212" y="589"/>
                  </a:cubicBezTo>
                  <a:cubicBezTo>
                    <a:pt x="202" y="582"/>
                    <a:pt x="217" y="565"/>
                    <a:pt x="212" y="549"/>
                  </a:cubicBezTo>
                  <a:cubicBezTo>
                    <a:pt x="199" y="568"/>
                    <a:pt x="196" y="597"/>
                    <a:pt x="180" y="613"/>
                  </a:cubicBezTo>
                  <a:cubicBezTo>
                    <a:pt x="196" y="568"/>
                    <a:pt x="202" y="514"/>
                    <a:pt x="228" y="477"/>
                  </a:cubicBezTo>
                  <a:cubicBezTo>
                    <a:pt x="265" y="424"/>
                    <a:pt x="341" y="397"/>
                    <a:pt x="332" y="305"/>
                  </a:cubicBezTo>
                  <a:cubicBezTo>
                    <a:pt x="303" y="332"/>
                    <a:pt x="307" y="447"/>
                    <a:pt x="212" y="409"/>
                  </a:cubicBezTo>
                  <a:cubicBezTo>
                    <a:pt x="214" y="400"/>
                    <a:pt x="232" y="407"/>
                    <a:pt x="240" y="405"/>
                  </a:cubicBezTo>
                  <a:cubicBezTo>
                    <a:pt x="248" y="398"/>
                    <a:pt x="223" y="391"/>
                    <a:pt x="228" y="373"/>
                  </a:cubicBezTo>
                  <a:cubicBezTo>
                    <a:pt x="277" y="450"/>
                    <a:pt x="330" y="329"/>
                    <a:pt x="300" y="269"/>
                  </a:cubicBezTo>
                  <a:cubicBezTo>
                    <a:pt x="258" y="279"/>
                    <a:pt x="216" y="323"/>
                    <a:pt x="164" y="297"/>
                  </a:cubicBezTo>
                  <a:cubicBezTo>
                    <a:pt x="214" y="303"/>
                    <a:pt x="255" y="276"/>
                    <a:pt x="296" y="261"/>
                  </a:cubicBezTo>
                  <a:cubicBezTo>
                    <a:pt x="200" y="201"/>
                    <a:pt x="83" y="336"/>
                    <a:pt x="0" y="265"/>
                  </a:cubicBezTo>
                  <a:cubicBezTo>
                    <a:pt x="80" y="313"/>
                    <a:pt x="170" y="220"/>
                    <a:pt x="272" y="241"/>
                  </a:cubicBezTo>
                  <a:cubicBezTo>
                    <a:pt x="254" y="217"/>
                    <a:pt x="218" y="167"/>
                    <a:pt x="168" y="161"/>
                  </a:cubicBezTo>
                  <a:cubicBezTo>
                    <a:pt x="127" y="157"/>
                    <a:pt x="106" y="181"/>
                    <a:pt x="68" y="193"/>
                  </a:cubicBezTo>
                  <a:cubicBezTo>
                    <a:pt x="78" y="179"/>
                    <a:pt x="94" y="171"/>
                    <a:pt x="112" y="165"/>
                  </a:cubicBezTo>
                  <a:cubicBezTo>
                    <a:pt x="76" y="150"/>
                    <a:pt x="57" y="201"/>
                    <a:pt x="16" y="181"/>
                  </a:cubicBezTo>
                  <a:cubicBezTo>
                    <a:pt x="37" y="176"/>
                    <a:pt x="61" y="173"/>
                    <a:pt x="76" y="161"/>
                  </a:cubicBezTo>
                  <a:cubicBezTo>
                    <a:pt x="65" y="155"/>
                    <a:pt x="53" y="150"/>
                    <a:pt x="44" y="141"/>
                  </a:cubicBezTo>
                  <a:cubicBezTo>
                    <a:pt x="74" y="158"/>
                    <a:pt x="127" y="147"/>
                    <a:pt x="168" y="153"/>
                  </a:cubicBezTo>
                  <a:cubicBezTo>
                    <a:pt x="232" y="163"/>
                    <a:pt x="258" y="224"/>
                    <a:pt x="304" y="245"/>
                  </a:cubicBezTo>
                  <a:cubicBezTo>
                    <a:pt x="427" y="231"/>
                    <a:pt x="372" y="66"/>
                    <a:pt x="284" y="53"/>
                  </a:cubicBezTo>
                  <a:cubicBezTo>
                    <a:pt x="348" y="54"/>
                    <a:pt x="410" y="139"/>
                    <a:pt x="376" y="213"/>
                  </a:cubicBezTo>
                  <a:cubicBezTo>
                    <a:pt x="433" y="162"/>
                    <a:pt x="520" y="133"/>
                    <a:pt x="554" y="0"/>
                  </a:cubicBezTo>
                  <a:cubicBezTo>
                    <a:pt x="562" y="7"/>
                    <a:pt x="555" y="49"/>
                    <a:pt x="548" y="55"/>
                  </a:cubicBezTo>
                  <a:cubicBezTo>
                    <a:pt x="557" y="58"/>
                    <a:pt x="568" y="52"/>
                    <a:pt x="576" y="65"/>
                  </a:cubicBezTo>
                  <a:cubicBezTo>
                    <a:pt x="541" y="51"/>
                    <a:pt x="523" y="106"/>
                    <a:pt x="500" y="129"/>
                  </a:cubicBezTo>
                  <a:cubicBezTo>
                    <a:pt x="531" y="120"/>
                    <a:pt x="561" y="130"/>
                    <a:pt x="584" y="141"/>
                  </a:cubicBezTo>
                  <a:lnTo>
                    <a:pt x="619" y="167"/>
                  </a:lnTo>
                  <a:close/>
                </a:path>
              </a:pathLst>
            </a:custGeom>
            <a:solidFill>
              <a:srgbClr val="23FF49"/>
            </a:solidFill>
            <a:ln w="6350" cap="flat">
              <a:solidFill>
                <a:srgbClr val="FF6600"/>
              </a:solidFill>
              <a:prstDash val="solid"/>
              <a:miter lim="800000"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en-US">
                <a:solidFill>
                  <a:srgbClr val="000000"/>
                </a:solidFill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>
              <a:off x="5410200" y="1905000"/>
              <a:ext cx="0" cy="1219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H="1">
              <a:off x="7467600" y="1143000"/>
              <a:ext cx="68580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802" name="Freeform 11"/>
            <p:cNvSpPr>
              <a:spLocks noChangeAspect="1"/>
            </p:cNvSpPr>
            <p:nvPr/>
          </p:nvSpPr>
          <p:spPr bwMode="auto">
            <a:xfrm>
              <a:off x="8382001" y="838200"/>
              <a:ext cx="917575" cy="596900"/>
            </a:xfrm>
            <a:custGeom>
              <a:avLst/>
              <a:gdLst>
                <a:gd name="T0" fmla="*/ 2147483647 w 619"/>
                <a:gd name="T1" fmla="*/ 2147483647 h 613"/>
                <a:gd name="T2" fmla="*/ 2147483647 w 619"/>
                <a:gd name="T3" fmla="*/ 2147483647 h 613"/>
                <a:gd name="T4" fmla="*/ 2147483647 w 619"/>
                <a:gd name="T5" fmla="*/ 2147483647 h 613"/>
                <a:gd name="T6" fmla="*/ 2147483647 w 619"/>
                <a:gd name="T7" fmla="*/ 2147483647 h 613"/>
                <a:gd name="T8" fmla="*/ 2147483647 w 619"/>
                <a:gd name="T9" fmla="*/ 2147483647 h 613"/>
                <a:gd name="T10" fmla="*/ 2147483647 w 619"/>
                <a:gd name="T11" fmla="*/ 2147483647 h 613"/>
                <a:gd name="T12" fmla="*/ 2147483647 w 619"/>
                <a:gd name="T13" fmla="*/ 2147483647 h 613"/>
                <a:gd name="T14" fmla="*/ 2147483647 w 619"/>
                <a:gd name="T15" fmla="*/ 2147483647 h 613"/>
                <a:gd name="T16" fmla="*/ 2147483647 w 619"/>
                <a:gd name="T17" fmla="*/ 2147483647 h 613"/>
                <a:gd name="T18" fmla="*/ 2147483647 w 619"/>
                <a:gd name="T19" fmla="*/ 2147483647 h 613"/>
                <a:gd name="T20" fmla="*/ 2147483647 w 619"/>
                <a:gd name="T21" fmla="*/ 2147483647 h 613"/>
                <a:gd name="T22" fmla="*/ 2147483647 w 619"/>
                <a:gd name="T23" fmla="*/ 2147483647 h 613"/>
                <a:gd name="T24" fmla="*/ 2147483647 w 619"/>
                <a:gd name="T25" fmla="*/ 2147483647 h 613"/>
                <a:gd name="T26" fmla="*/ 2147483647 w 619"/>
                <a:gd name="T27" fmla="*/ 2147483647 h 613"/>
                <a:gd name="T28" fmla="*/ 2147483647 w 619"/>
                <a:gd name="T29" fmla="*/ 2147483647 h 613"/>
                <a:gd name="T30" fmla="*/ 2147483647 w 619"/>
                <a:gd name="T31" fmla="*/ 2147483647 h 613"/>
                <a:gd name="T32" fmla="*/ 2147483647 w 619"/>
                <a:gd name="T33" fmla="*/ 2147483647 h 613"/>
                <a:gd name="T34" fmla="*/ 2147483647 w 619"/>
                <a:gd name="T35" fmla="*/ 2147483647 h 613"/>
                <a:gd name="T36" fmla="*/ 2147483647 w 619"/>
                <a:gd name="T37" fmla="*/ 2147483647 h 613"/>
                <a:gd name="T38" fmla="*/ 2147483647 w 619"/>
                <a:gd name="T39" fmla="*/ 2147483647 h 613"/>
                <a:gd name="T40" fmla="*/ 2147483647 w 619"/>
                <a:gd name="T41" fmla="*/ 2147483647 h 613"/>
                <a:gd name="T42" fmla="*/ 2147483647 w 619"/>
                <a:gd name="T43" fmla="*/ 2147483647 h 613"/>
                <a:gd name="T44" fmla="*/ 2147483647 w 619"/>
                <a:gd name="T45" fmla="*/ 2147483647 h 613"/>
                <a:gd name="T46" fmla="*/ 2147483647 w 619"/>
                <a:gd name="T47" fmla="*/ 2147483647 h 613"/>
                <a:gd name="T48" fmla="*/ 2147483647 w 619"/>
                <a:gd name="T49" fmla="*/ 2147483647 h 613"/>
                <a:gd name="T50" fmla="*/ 2147483647 w 619"/>
                <a:gd name="T51" fmla="*/ 2147483647 h 613"/>
                <a:gd name="T52" fmla="*/ 2147483647 w 619"/>
                <a:gd name="T53" fmla="*/ 2147483647 h 613"/>
                <a:gd name="T54" fmla="*/ 0 w 619"/>
                <a:gd name="T55" fmla="*/ 2147483647 h 613"/>
                <a:gd name="T56" fmla="*/ 2147483647 w 619"/>
                <a:gd name="T57" fmla="*/ 2147483647 h 613"/>
                <a:gd name="T58" fmla="*/ 2147483647 w 619"/>
                <a:gd name="T59" fmla="*/ 2147483647 h 613"/>
                <a:gd name="T60" fmla="*/ 2147483647 w 619"/>
                <a:gd name="T61" fmla="*/ 2147483647 h 613"/>
                <a:gd name="T62" fmla="*/ 2147483647 w 619"/>
                <a:gd name="T63" fmla="*/ 2147483647 h 613"/>
                <a:gd name="T64" fmla="*/ 2147483647 w 619"/>
                <a:gd name="T65" fmla="*/ 2147483647 h 613"/>
                <a:gd name="T66" fmla="*/ 2147483647 w 619"/>
                <a:gd name="T67" fmla="*/ 2147483647 h 613"/>
                <a:gd name="T68" fmla="*/ 2147483647 w 619"/>
                <a:gd name="T69" fmla="*/ 2147483647 h 613"/>
                <a:gd name="T70" fmla="*/ 2147483647 w 619"/>
                <a:gd name="T71" fmla="*/ 2147483647 h 613"/>
                <a:gd name="T72" fmla="*/ 2147483647 w 619"/>
                <a:gd name="T73" fmla="*/ 2147483647 h 613"/>
                <a:gd name="T74" fmla="*/ 2147483647 w 619"/>
                <a:gd name="T75" fmla="*/ 2147483647 h 613"/>
                <a:gd name="T76" fmla="*/ 2147483647 w 619"/>
                <a:gd name="T77" fmla="*/ 2147483647 h 613"/>
                <a:gd name="T78" fmla="*/ 2147483647 w 619"/>
                <a:gd name="T79" fmla="*/ 0 h 613"/>
                <a:gd name="T80" fmla="*/ 2147483647 w 619"/>
                <a:gd name="T81" fmla="*/ 2147483647 h 613"/>
                <a:gd name="T82" fmla="*/ 2147483647 w 619"/>
                <a:gd name="T83" fmla="*/ 2147483647 h 613"/>
                <a:gd name="T84" fmla="*/ 2147483647 w 619"/>
                <a:gd name="T85" fmla="*/ 2147483647 h 613"/>
                <a:gd name="T86" fmla="*/ 2147483647 w 619"/>
                <a:gd name="T87" fmla="*/ 2147483647 h 613"/>
                <a:gd name="T88" fmla="*/ 2147483647 w 619"/>
                <a:gd name="T89" fmla="*/ 2147483647 h 613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</a:gdLst>
              <a:ahLst/>
              <a:cxnLst>
                <a:cxn ang="T90">
                  <a:pos x="T0" y="T1"/>
                </a:cxn>
                <a:cxn ang="T91">
                  <a:pos x="T2" y="T3"/>
                </a:cxn>
                <a:cxn ang="T92">
                  <a:pos x="T4" y="T5"/>
                </a:cxn>
                <a:cxn ang="T93">
                  <a:pos x="T6" y="T7"/>
                </a:cxn>
                <a:cxn ang="T94">
                  <a:pos x="T8" y="T9"/>
                </a:cxn>
                <a:cxn ang="T95">
                  <a:pos x="T10" y="T11"/>
                </a:cxn>
                <a:cxn ang="T96">
                  <a:pos x="T12" y="T13"/>
                </a:cxn>
                <a:cxn ang="T97">
                  <a:pos x="T14" y="T15"/>
                </a:cxn>
                <a:cxn ang="T98">
                  <a:pos x="T16" y="T17"/>
                </a:cxn>
                <a:cxn ang="T99">
                  <a:pos x="T18" y="T19"/>
                </a:cxn>
                <a:cxn ang="T100">
                  <a:pos x="T20" y="T21"/>
                </a:cxn>
                <a:cxn ang="T101">
                  <a:pos x="T22" y="T23"/>
                </a:cxn>
                <a:cxn ang="T102">
                  <a:pos x="T24" y="T25"/>
                </a:cxn>
                <a:cxn ang="T103">
                  <a:pos x="T26" y="T27"/>
                </a:cxn>
                <a:cxn ang="T104">
                  <a:pos x="T28" y="T29"/>
                </a:cxn>
                <a:cxn ang="T105">
                  <a:pos x="T30" y="T31"/>
                </a:cxn>
                <a:cxn ang="T106">
                  <a:pos x="T32" y="T33"/>
                </a:cxn>
                <a:cxn ang="T107">
                  <a:pos x="T34" y="T35"/>
                </a:cxn>
                <a:cxn ang="T108">
                  <a:pos x="T36" y="T37"/>
                </a:cxn>
                <a:cxn ang="T109">
                  <a:pos x="T38" y="T39"/>
                </a:cxn>
                <a:cxn ang="T110">
                  <a:pos x="T40" y="T41"/>
                </a:cxn>
                <a:cxn ang="T111">
                  <a:pos x="T42" y="T43"/>
                </a:cxn>
                <a:cxn ang="T112">
                  <a:pos x="T44" y="T45"/>
                </a:cxn>
                <a:cxn ang="T113">
                  <a:pos x="T46" y="T47"/>
                </a:cxn>
                <a:cxn ang="T114">
                  <a:pos x="T48" y="T49"/>
                </a:cxn>
                <a:cxn ang="T115">
                  <a:pos x="T50" y="T51"/>
                </a:cxn>
                <a:cxn ang="T116">
                  <a:pos x="T52" y="T53"/>
                </a:cxn>
                <a:cxn ang="T117">
                  <a:pos x="T54" y="T55"/>
                </a:cxn>
                <a:cxn ang="T118">
                  <a:pos x="T56" y="T57"/>
                </a:cxn>
                <a:cxn ang="T119">
                  <a:pos x="T58" y="T59"/>
                </a:cxn>
                <a:cxn ang="T120">
                  <a:pos x="T60" y="T61"/>
                </a:cxn>
                <a:cxn ang="T121">
                  <a:pos x="T62" y="T63"/>
                </a:cxn>
                <a:cxn ang="T122">
                  <a:pos x="T64" y="T65"/>
                </a:cxn>
                <a:cxn ang="T123">
                  <a:pos x="T66" y="T67"/>
                </a:cxn>
                <a:cxn ang="T124">
                  <a:pos x="T68" y="T69"/>
                </a:cxn>
                <a:cxn ang="T125">
                  <a:pos x="T70" y="T71"/>
                </a:cxn>
                <a:cxn ang="T126">
                  <a:pos x="T72" y="T73"/>
                </a:cxn>
                <a:cxn ang="T127">
                  <a:pos x="T74" y="T75"/>
                </a:cxn>
                <a:cxn ang="T128">
                  <a:pos x="T76" y="T77"/>
                </a:cxn>
                <a:cxn ang="T129">
                  <a:pos x="T78" y="T79"/>
                </a:cxn>
                <a:cxn ang="T130">
                  <a:pos x="T80" y="T81"/>
                </a:cxn>
                <a:cxn ang="T131">
                  <a:pos x="T82" y="T83"/>
                </a:cxn>
                <a:cxn ang="T132">
                  <a:pos x="T84" y="T85"/>
                </a:cxn>
                <a:cxn ang="T133">
                  <a:pos x="T86" y="T87"/>
                </a:cxn>
                <a:cxn ang="T134">
                  <a:pos x="T88" y="T89"/>
                </a:cxn>
              </a:cxnLst>
              <a:rect l="0" t="0" r="r" b="b"/>
              <a:pathLst>
                <a:path w="619" h="613">
                  <a:moveTo>
                    <a:pt x="619" y="167"/>
                  </a:moveTo>
                  <a:cubicBezTo>
                    <a:pt x="585" y="148"/>
                    <a:pt x="543" y="130"/>
                    <a:pt x="520" y="133"/>
                  </a:cubicBezTo>
                  <a:cubicBezTo>
                    <a:pt x="472" y="138"/>
                    <a:pt x="371" y="229"/>
                    <a:pt x="375" y="251"/>
                  </a:cubicBezTo>
                  <a:cubicBezTo>
                    <a:pt x="378" y="269"/>
                    <a:pt x="375" y="277"/>
                    <a:pt x="368" y="289"/>
                  </a:cubicBezTo>
                  <a:cubicBezTo>
                    <a:pt x="393" y="327"/>
                    <a:pt x="489" y="313"/>
                    <a:pt x="524" y="361"/>
                  </a:cubicBezTo>
                  <a:cubicBezTo>
                    <a:pt x="501" y="363"/>
                    <a:pt x="476" y="332"/>
                    <a:pt x="440" y="333"/>
                  </a:cubicBezTo>
                  <a:cubicBezTo>
                    <a:pt x="459" y="373"/>
                    <a:pt x="518" y="407"/>
                    <a:pt x="528" y="469"/>
                  </a:cubicBezTo>
                  <a:cubicBezTo>
                    <a:pt x="487" y="397"/>
                    <a:pt x="436" y="334"/>
                    <a:pt x="356" y="301"/>
                  </a:cubicBezTo>
                  <a:cubicBezTo>
                    <a:pt x="375" y="362"/>
                    <a:pt x="381" y="415"/>
                    <a:pt x="412" y="457"/>
                  </a:cubicBezTo>
                  <a:cubicBezTo>
                    <a:pt x="446" y="504"/>
                    <a:pt x="509" y="503"/>
                    <a:pt x="536" y="557"/>
                  </a:cubicBezTo>
                  <a:cubicBezTo>
                    <a:pt x="494" y="511"/>
                    <a:pt x="412" y="505"/>
                    <a:pt x="392" y="437"/>
                  </a:cubicBezTo>
                  <a:cubicBezTo>
                    <a:pt x="372" y="468"/>
                    <a:pt x="379" y="533"/>
                    <a:pt x="396" y="561"/>
                  </a:cubicBezTo>
                  <a:cubicBezTo>
                    <a:pt x="349" y="530"/>
                    <a:pt x="379" y="464"/>
                    <a:pt x="375" y="413"/>
                  </a:cubicBezTo>
                  <a:cubicBezTo>
                    <a:pt x="371" y="369"/>
                    <a:pt x="348" y="339"/>
                    <a:pt x="348" y="301"/>
                  </a:cubicBezTo>
                  <a:cubicBezTo>
                    <a:pt x="339" y="360"/>
                    <a:pt x="344" y="379"/>
                    <a:pt x="304" y="421"/>
                  </a:cubicBezTo>
                  <a:cubicBezTo>
                    <a:pt x="284" y="442"/>
                    <a:pt x="253" y="456"/>
                    <a:pt x="236" y="481"/>
                  </a:cubicBezTo>
                  <a:cubicBezTo>
                    <a:pt x="216" y="511"/>
                    <a:pt x="227" y="549"/>
                    <a:pt x="212" y="589"/>
                  </a:cubicBezTo>
                  <a:cubicBezTo>
                    <a:pt x="202" y="582"/>
                    <a:pt x="217" y="565"/>
                    <a:pt x="212" y="549"/>
                  </a:cubicBezTo>
                  <a:cubicBezTo>
                    <a:pt x="199" y="568"/>
                    <a:pt x="196" y="597"/>
                    <a:pt x="180" y="613"/>
                  </a:cubicBezTo>
                  <a:cubicBezTo>
                    <a:pt x="196" y="568"/>
                    <a:pt x="202" y="514"/>
                    <a:pt x="228" y="477"/>
                  </a:cubicBezTo>
                  <a:cubicBezTo>
                    <a:pt x="265" y="424"/>
                    <a:pt x="341" y="397"/>
                    <a:pt x="332" y="305"/>
                  </a:cubicBezTo>
                  <a:cubicBezTo>
                    <a:pt x="303" y="332"/>
                    <a:pt x="307" y="447"/>
                    <a:pt x="212" y="409"/>
                  </a:cubicBezTo>
                  <a:cubicBezTo>
                    <a:pt x="214" y="400"/>
                    <a:pt x="232" y="407"/>
                    <a:pt x="240" y="405"/>
                  </a:cubicBezTo>
                  <a:cubicBezTo>
                    <a:pt x="248" y="398"/>
                    <a:pt x="223" y="391"/>
                    <a:pt x="228" y="373"/>
                  </a:cubicBezTo>
                  <a:cubicBezTo>
                    <a:pt x="277" y="450"/>
                    <a:pt x="330" y="329"/>
                    <a:pt x="300" y="269"/>
                  </a:cubicBezTo>
                  <a:cubicBezTo>
                    <a:pt x="258" y="279"/>
                    <a:pt x="216" y="323"/>
                    <a:pt x="164" y="297"/>
                  </a:cubicBezTo>
                  <a:cubicBezTo>
                    <a:pt x="214" y="303"/>
                    <a:pt x="255" y="276"/>
                    <a:pt x="296" y="261"/>
                  </a:cubicBezTo>
                  <a:cubicBezTo>
                    <a:pt x="200" y="201"/>
                    <a:pt x="83" y="336"/>
                    <a:pt x="0" y="265"/>
                  </a:cubicBezTo>
                  <a:cubicBezTo>
                    <a:pt x="80" y="313"/>
                    <a:pt x="170" y="220"/>
                    <a:pt x="272" y="241"/>
                  </a:cubicBezTo>
                  <a:cubicBezTo>
                    <a:pt x="254" y="217"/>
                    <a:pt x="218" y="167"/>
                    <a:pt x="168" y="161"/>
                  </a:cubicBezTo>
                  <a:cubicBezTo>
                    <a:pt x="127" y="157"/>
                    <a:pt x="106" y="181"/>
                    <a:pt x="68" y="193"/>
                  </a:cubicBezTo>
                  <a:cubicBezTo>
                    <a:pt x="78" y="179"/>
                    <a:pt x="94" y="171"/>
                    <a:pt x="112" y="165"/>
                  </a:cubicBezTo>
                  <a:cubicBezTo>
                    <a:pt x="76" y="150"/>
                    <a:pt x="57" y="201"/>
                    <a:pt x="16" y="181"/>
                  </a:cubicBezTo>
                  <a:cubicBezTo>
                    <a:pt x="37" y="176"/>
                    <a:pt x="61" y="173"/>
                    <a:pt x="76" y="161"/>
                  </a:cubicBezTo>
                  <a:cubicBezTo>
                    <a:pt x="65" y="155"/>
                    <a:pt x="53" y="150"/>
                    <a:pt x="44" y="141"/>
                  </a:cubicBezTo>
                  <a:cubicBezTo>
                    <a:pt x="74" y="158"/>
                    <a:pt x="127" y="147"/>
                    <a:pt x="168" y="153"/>
                  </a:cubicBezTo>
                  <a:cubicBezTo>
                    <a:pt x="232" y="163"/>
                    <a:pt x="258" y="224"/>
                    <a:pt x="304" y="245"/>
                  </a:cubicBezTo>
                  <a:cubicBezTo>
                    <a:pt x="427" y="231"/>
                    <a:pt x="372" y="66"/>
                    <a:pt x="284" y="53"/>
                  </a:cubicBezTo>
                  <a:cubicBezTo>
                    <a:pt x="348" y="54"/>
                    <a:pt x="410" y="139"/>
                    <a:pt x="376" y="213"/>
                  </a:cubicBezTo>
                  <a:cubicBezTo>
                    <a:pt x="433" y="162"/>
                    <a:pt x="520" y="133"/>
                    <a:pt x="554" y="0"/>
                  </a:cubicBezTo>
                  <a:cubicBezTo>
                    <a:pt x="562" y="7"/>
                    <a:pt x="555" y="49"/>
                    <a:pt x="548" y="55"/>
                  </a:cubicBezTo>
                  <a:cubicBezTo>
                    <a:pt x="557" y="58"/>
                    <a:pt x="568" y="52"/>
                    <a:pt x="576" y="65"/>
                  </a:cubicBezTo>
                  <a:cubicBezTo>
                    <a:pt x="541" y="51"/>
                    <a:pt x="523" y="106"/>
                    <a:pt x="500" y="129"/>
                  </a:cubicBezTo>
                  <a:cubicBezTo>
                    <a:pt x="531" y="120"/>
                    <a:pt x="561" y="130"/>
                    <a:pt x="584" y="141"/>
                  </a:cubicBezTo>
                  <a:lnTo>
                    <a:pt x="619" y="167"/>
                  </a:lnTo>
                  <a:close/>
                </a:path>
              </a:pathLst>
            </a:custGeom>
            <a:solidFill>
              <a:srgbClr val="FFF5EE"/>
            </a:solidFill>
            <a:ln w="6350" cap="flat">
              <a:solidFill>
                <a:srgbClr val="FF6600"/>
              </a:solidFill>
              <a:prstDash val="solid"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416602" y="835224"/>
              <a:ext cx="83965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US" sz="1400" dirty="0">
                  <a:solidFill>
                    <a:srgbClr val="000000"/>
                  </a:solidFill>
                </a:rPr>
                <a:t>CMFDA</a:t>
              </a:r>
              <a:endParaRPr lang="en-US" sz="1400" dirty="0">
                <a:solidFill>
                  <a:srgbClr val="000000"/>
                </a:solidFill>
              </a:endParaRPr>
            </a:p>
          </p:txBody>
        </p:sp>
        <p:grpSp>
          <p:nvGrpSpPr>
            <p:cNvPr id="19" name="Group 18"/>
            <p:cNvGrpSpPr>
              <a:grpSpLocks/>
            </p:cNvGrpSpPr>
            <p:nvPr/>
          </p:nvGrpSpPr>
          <p:grpSpPr bwMode="auto">
            <a:xfrm>
              <a:off x="5540556" y="2528272"/>
              <a:ext cx="1115568" cy="502920"/>
              <a:chOff x="3404612" y="2734200"/>
              <a:chExt cx="1345333" cy="851076"/>
            </a:xfrm>
          </p:grpSpPr>
          <p:grpSp>
            <p:nvGrpSpPr>
              <p:cNvPr id="25719" name="Group 179"/>
              <p:cNvGrpSpPr>
                <a:grpSpLocks/>
              </p:cNvGrpSpPr>
              <p:nvPr/>
            </p:nvGrpSpPr>
            <p:grpSpPr bwMode="auto">
              <a:xfrm>
                <a:off x="4173261" y="2846677"/>
                <a:ext cx="300879" cy="738599"/>
                <a:chOff x="4173261" y="2846677"/>
                <a:chExt cx="300879" cy="738599"/>
              </a:xfrm>
            </p:grpSpPr>
            <p:grpSp>
              <p:nvGrpSpPr>
                <p:cNvPr id="25766" name="Group 63"/>
                <p:cNvGrpSpPr>
                  <a:grpSpLocks/>
                </p:cNvGrpSpPr>
                <p:nvPr/>
              </p:nvGrpSpPr>
              <p:grpSpPr bwMode="auto">
                <a:xfrm>
                  <a:off x="4213981" y="2846677"/>
                  <a:ext cx="260159" cy="302136"/>
                  <a:chOff x="1440" y="720"/>
                  <a:chExt cx="2879" cy="2879"/>
                </a:xfrm>
              </p:grpSpPr>
              <p:sp>
                <p:nvSpPr>
                  <p:cNvPr id="25785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786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48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0" y="2036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9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20" y="1733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0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86" y="1789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1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6" y="1354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2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3" y="1827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3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17" y="1827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4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08" y="1088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5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4" y="1467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6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0" y="1088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7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4" y="1088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8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6" y="1676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59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12" y="1827"/>
                    <a:ext cx="191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60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3" y="1467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61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5" y="1448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62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33" y="1467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767" name="Group 63"/>
                <p:cNvGrpSpPr>
                  <a:grpSpLocks noChangeAspect="1"/>
                </p:cNvGrpSpPr>
                <p:nvPr/>
              </p:nvGrpSpPr>
              <p:grpSpPr bwMode="auto">
                <a:xfrm>
                  <a:off x="4173261" y="3277752"/>
                  <a:ext cx="264799" cy="307524"/>
                  <a:chOff x="1440" y="720"/>
                  <a:chExt cx="2879" cy="2879"/>
                </a:xfrm>
              </p:grpSpPr>
              <p:sp>
                <p:nvSpPr>
                  <p:cNvPr id="25768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769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31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0" y="2035"/>
                    <a:ext cx="170" cy="16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2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08" y="1737"/>
                    <a:ext cx="187" cy="16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3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82" y="1775"/>
                    <a:ext cx="170" cy="18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4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4" y="1346"/>
                    <a:ext cx="187" cy="18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5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0" y="1830"/>
                    <a:ext cx="170" cy="18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6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25" y="1830"/>
                    <a:ext cx="170" cy="18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7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12" y="1346"/>
                    <a:ext cx="170" cy="7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8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38" y="1477"/>
                    <a:ext cx="187" cy="16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39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0" y="1346"/>
                    <a:ext cx="170" cy="7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0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38" y="1346"/>
                    <a:ext cx="187" cy="7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1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4" y="1682"/>
                    <a:ext cx="170" cy="18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2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15" y="1830"/>
                    <a:ext cx="187" cy="18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3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0" y="1477"/>
                    <a:ext cx="170" cy="16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4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9" y="1458"/>
                    <a:ext cx="170" cy="16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45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40" y="1477"/>
                    <a:ext cx="170" cy="16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  <p:grpSp>
            <p:nvGrpSpPr>
              <p:cNvPr id="25720" name="Group 180"/>
              <p:cNvGrpSpPr>
                <a:grpSpLocks/>
              </p:cNvGrpSpPr>
              <p:nvPr/>
            </p:nvGrpSpPr>
            <p:grpSpPr bwMode="auto">
              <a:xfrm>
                <a:off x="3404612" y="2734200"/>
                <a:ext cx="1345333" cy="846175"/>
                <a:chOff x="3404612" y="2734200"/>
                <a:chExt cx="1345333" cy="846175"/>
              </a:xfrm>
            </p:grpSpPr>
            <p:grpSp>
              <p:nvGrpSpPr>
                <p:cNvPr id="25721" name="Group 63"/>
                <p:cNvGrpSpPr>
                  <a:grpSpLocks/>
                </p:cNvGrpSpPr>
                <p:nvPr/>
              </p:nvGrpSpPr>
              <p:grpSpPr bwMode="auto">
                <a:xfrm>
                  <a:off x="3601976" y="2734200"/>
                  <a:ext cx="260159" cy="302136"/>
                  <a:chOff x="1440" y="720"/>
                  <a:chExt cx="2879" cy="2879"/>
                </a:xfrm>
              </p:grpSpPr>
              <p:sp>
                <p:nvSpPr>
                  <p:cNvPr id="25749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750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12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76" y="2027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3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16" y="1724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4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82" y="1781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5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2" y="1345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6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49" y="1819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7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13" y="1819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8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04" y="1080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19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0" y="1459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0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76" y="1080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1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0" y="1080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2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2" y="1667"/>
                    <a:ext cx="173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3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08" y="1819"/>
                    <a:ext cx="191" cy="189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4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49" y="1459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5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1" y="1440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26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29" y="1459"/>
                    <a:ext cx="173" cy="171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722" name="Group 63"/>
                <p:cNvGrpSpPr>
                  <a:grpSpLocks noChangeAspect="1"/>
                </p:cNvGrpSpPr>
                <p:nvPr/>
              </p:nvGrpSpPr>
              <p:grpSpPr bwMode="auto">
                <a:xfrm>
                  <a:off x="3649940" y="3306554"/>
                  <a:ext cx="235778" cy="273821"/>
                  <a:chOff x="1440" y="720"/>
                  <a:chExt cx="2879" cy="2879"/>
                </a:xfrm>
              </p:grpSpPr>
              <p:sp>
                <p:nvSpPr>
                  <p:cNvPr id="25732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733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195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4" y="2020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96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16" y="1727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97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95" y="1790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98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12" y="1351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99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6" y="1832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0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19" y="1832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1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11" y="1100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2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7" y="1455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3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4" y="1100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4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7" y="1100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5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493" y="1685"/>
                    <a:ext cx="191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6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25" y="1832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7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6" y="1455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8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30" y="1455"/>
                    <a:ext cx="172" cy="167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209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40" y="1455"/>
                    <a:ext cx="172" cy="188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723" name="Group 10"/>
                <p:cNvGrpSpPr>
                  <a:grpSpLocks/>
                </p:cNvGrpSpPr>
                <p:nvPr/>
              </p:nvGrpSpPr>
              <p:grpSpPr bwMode="auto">
                <a:xfrm>
                  <a:off x="3812817" y="2878020"/>
                  <a:ext cx="362297" cy="535029"/>
                  <a:chOff x="1137" y="421"/>
                  <a:chExt cx="3501" cy="3467"/>
                </a:xfrm>
              </p:grpSpPr>
              <p:sp>
                <p:nvSpPr>
                  <p:cNvPr id="25730" name="Freeform 11"/>
                  <p:cNvSpPr>
                    <a:spLocks noChangeAspect="1"/>
                  </p:cNvSpPr>
                  <p:nvPr/>
                </p:nvSpPr>
                <p:spPr bwMode="auto">
                  <a:xfrm>
                    <a:off x="1137" y="421"/>
                    <a:ext cx="3501" cy="3467"/>
                  </a:xfrm>
                  <a:custGeom>
                    <a:avLst/>
                    <a:gdLst>
                      <a:gd name="T0" fmla="*/ 2147483647 w 619"/>
                      <a:gd name="T1" fmla="*/ 2147483647 h 613"/>
                      <a:gd name="T2" fmla="*/ 2147483647 w 619"/>
                      <a:gd name="T3" fmla="*/ 2147483647 h 613"/>
                      <a:gd name="T4" fmla="*/ 2147483647 w 619"/>
                      <a:gd name="T5" fmla="*/ 2147483647 h 613"/>
                      <a:gd name="T6" fmla="*/ 2147483647 w 619"/>
                      <a:gd name="T7" fmla="*/ 2147483647 h 613"/>
                      <a:gd name="T8" fmla="*/ 2147483647 w 619"/>
                      <a:gd name="T9" fmla="*/ 2147483647 h 613"/>
                      <a:gd name="T10" fmla="*/ 2147483647 w 619"/>
                      <a:gd name="T11" fmla="*/ 2147483647 h 613"/>
                      <a:gd name="T12" fmla="*/ 2147483647 w 619"/>
                      <a:gd name="T13" fmla="*/ 2147483647 h 613"/>
                      <a:gd name="T14" fmla="*/ 2147483647 w 619"/>
                      <a:gd name="T15" fmla="*/ 2147483647 h 613"/>
                      <a:gd name="T16" fmla="*/ 2147483647 w 619"/>
                      <a:gd name="T17" fmla="*/ 2147483647 h 613"/>
                      <a:gd name="T18" fmla="*/ 2147483647 w 619"/>
                      <a:gd name="T19" fmla="*/ 2147483647 h 613"/>
                      <a:gd name="T20" fmla="*/ 2147483647 w 619"/>
                      <a:gd name="T21" fmla="*/ 2147483647 h 613"/>
                      <a:gd name="T22" fmla="*/ 2147483647 w 619"/>
                      <a:gd name="T23" fmla="*/ 2147483647 h 613"/>
                      <a:gd name="T24" fmla="*/ 2147483647 w 619"/>
                      <a:gd name="T25" fmla="*/ 2147483647 h 613"/>
                      <a:gd name="T26" fmla="*/ 2147483647 w 619"/>
                      <a:gd name="T27" fmla="*/ 2147483647 h 613"/>
                      <a:gd name="T28" fmla="*/ 2147483647 w 619"/>
                      <a:gd name="T29" fmla="*/ 2147483647 h 613"/>
                      <a:gd name="T30" fmla="*/ 2147483647 w 619"/>
                      <a:gd name="T31" fmla="*/ 2147483647 h 613"/>
                      <a:gd name="T32" fmla="*/ 2147483647 w 619"/>
                      <a:gd name="T33" fmla="*/ 2147483647 h 613"/>
                      <a:gd name="T34" fmla="*/ 2147483647 w 619"/>
                      <a:gd name="T35" fmla="*/ 2147483647 h 613"/>
                      <a:gd name="T36" fmla="*/ 2147483647 w 619"/>
                      <a:gd name="T37" fmla="*/ 2147483647 h 613"/>
                      <a:gd name="T38" fmla="*/ 2147483647 w 619"/>
                      <a:gd name="T39" fmla="*/ 2147483647 h 613"/>
                      <a:gd name="T40" fmla="*/ 2147483647 w 619"/>
                      <a:gd name="T41" fmla="*/ 2147483647 h 613"/>
                      <a:gd name="T42" fmla="*/ 2147483647 w 619"/>
                      <a:gd name="T43" fmla="*/ 2147483647 h 613"/>
                      <a:gd name="T44" fmla="*/ 2147483647 w 619"/>
                      <a:gd name="T45" fmla="*/ 2147483647 h 613"/>
                      <a:gd name="T46" fmla="*/ 2147483647 w 619"/>
                      <a:gd name="T47" fmla="*/ 2147483647 h 613"/>
                      <a:gd name="T48" fmla="*/ 2147483647 w 619"/>
                      <a:gd name="T49" fmla="*/ 2147483647 h 613"/>
                      <a:gd name="T50" fmla="*/ 2147483647 w 619"/>
                      <a:gd name="T51" fmla="*/ 2147483647 h 613"/>
                      <a:gd name="T52" fmla="*/ 2147483647 w 619"/>
                      <a:gd name="T53" fmla="*/ 2147483647 h 613"/>
                      <a:gd name="T54" fmla="*/ 0 w 619"/>
                      <a:gd name="T55" fmla="*/ 2147483647 h 613"/>
                      <a:gd name="T56" fmla="*/ 2147483647 w 619"/>
                      <a:gd name="T57" fmla="*/ 2147483647 h 613"/>
                      <a:gd name="T58" fmla="*/ 2147483647 w 619"/>
                      <a:gd name="T59" fmla="*/ 2147483647 h 613"/>
                      <a:gd name="T60" fmla="*/ 2147483647 w 619"/>
                      <a:gd name="T61" fmla="*/ 2147483647 h 613"/>
                      <a:gd name="T62" fmla="*/ 2147483647 w 619"/>
                      <a:gd name="T63" fmla="*/ 2147483647 h 613"/>
                      <a:gd name="T64" fmla="*/ 2147483647 w 619"/>
                      <a:gd name="T65" fmla="*/ 2147483647 h 613"/>
                      <a:gd name="T66" fmla="*/ 2147483647 w 619"/>
                      <a:gd name="T67" fmla="*/ 2147483647 h 613"/>
                      <a:gd name="T68" fmla="*/ 2147483647 w 619"/>
                      <a:gd name="T69" fmla="*/ 2147483647 h 613"/>
                      <a:gd name="T70" fmla="*/ 2147483647 w 619"/>
                      <a:gd name="T71" fmla="*/ 2147483647 h 613"/>
                      <a:gd name="T72" fmla="*/ 2147483647 w 619"/>
                      <a:gd name="T73" fmla="*/ 2147483647 h 613"/>
                      <a:gd name="T74" fmla="*/ 2147483647 w 619"/>
                      <a:gd name="T75" fmla="*/ 2147483647 h 613"/>
                      <a:gd name="T76" fmla="*/ 2147483647 w 619"/>
                      <a:gd name="T77" fmla="*/ 2147483647 h 613"/>
                      <a:gd name="T78" fmla="*/ 2147483647 w 619"/>
                      <a:gd name="T79" fmla="*/ 0 h 613"/>
                      <a:gd name="T80" fmla="*/ 2147483647 w 619"/>
                      <a:gd name="T81" fmla="*/ 2147483647 h 613"/>
                      <a:gd name="T82" fmla="*/ 2147483647 w 619"/>
                      <a:gd name="T83" fmla="*/ 2147483647 h 613"/>
                      <a:gd name="T84" fmla="*/ 2147483647 w 619"/>
                      <a:gd name="T85" fmla="*/ 2147483647 h 613"/>
                      <a:gd name="T86" fmla="*/ 2147483647 w 619"/>
                      <a:gd name="T87" fmla="*/ 2147483647 h 613"/>
                      <a:gd name="T88" fmla="*/ 2147483647 w 619"/>
                      <a:gd name="T89" fmla="*/ 2147483647 h 613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</a:gdLst>
                    <a:ahLst/>
                    <a:cxnLst>
                      <a:cxn ang="T90">
                        <a:pos x="T0" y="T1"/>
                      </a:cxn>
                      <a:cxn ang="T91">
                        <a:pos x="T2" y="T3"/>
                      </a:cxn>
                      <a:cxn ang="T92">
                        <a:pos x="T4" y="T5"/>
                      </a:cxn>
                      <a:cxn ang="T93">
                        <a:pos x="T6" y="T7"/>
                      </a:cxn>
                      <a:cxn ang="T94">
                        <a:pos x="T8" y="T9"/>
                      </a:cxn>
                      <a:cxn ang="T95">
                        <a:pos x="T10" y="T11"/>
                      </a:cxn>
                      <a:cxn ang="T96">
                        <a:pos x="T12" y="T13"/>
                      </a:cxn>
                      <a:cxn ang="T97">
                        <a:pos x="T14" y="T15"/>
                      </a:cxn>
                      <a:cxn ang="T98">
                        <a:pos x="T16" y="T17"/>
                      </a:cxn>
                      <a:cxn ang="T99">
                        <a:pos x="T18" y="T19"/>
                      </a:cxn>
                      <a:cxn ang="T100">
                        <a:pos x="T20" y="T21"/>
                      </a:cxn>
                      <a:cxn ang="T101">
                        <a:pos x="T22" y="T23"/>
                      </a:cxn>
                      <a:cxn ang="T102">
                        <a:pos x="T24" y="T25"/>
                      </a:cxn>
                      <a:cxn ang="T103">
                        <a:pos x="T26" y="T27"/>
                      </a:cxn>
                      <a:cxn ang="T104">
                        <a:pos x="T28" y="T29"/>
                      </a:cxn>
                      <a:cxn ang="T105">
                        <a:pos x="T30" y="T31"/>
                      </a:cxn>
                      <a:cxn ang="T106">
                        <a:pos x="T32" y="T33"/>
                      </a:cxn>
                      <a:cxn ang="T107">
                        <a:pos x="T34" y="T35"/>
                      </a:cxn>
                      <a:cxn ang="T108">
                        <a:pos x="T36" y="T37"/>
                      </a:cxn>
                      <a:cxn ang="T109">
                        <a:pos x="T38" y="T39"/>
                      </a:cxn>
                      <a:cxn ang="T110">
                        <a:pos x="T40" y="T41"/>
                      </a:cxn>
                      <a:cxn ang="T111">
                        <a:pos x="T42" y="T43"/>
                      </a:cxn>
                      <a:cxn ang="T112">
                        <a:pos x="T44" y="T45"/>
                      </a:cxn>
                      <a:cxn ang="T113">
                        <a:pos x="T46" y="T47"/>
                      </a:cxn>
                      <a:cxn ang="T114">
                        <a:pos x="T48" y="T49"/>
                      </a:cxn>
                      <a:cxn ang="T115">
                        <a:pos x="T50" y="T51"/>
                      </a:cxn>
                      <a:cxn ang="T116">
                        <a:pos x="T52" y="T53"/>
                      </a:cxn>
                      <a:cxn ang="T117">
                        <a:pos x="T54" y="T55"/>
                      </a:cxn>
                      <a:cxn ang="T118">
                        <a:pos x="T56" y="T57"/>
                      </a:cxn>
                      <a:cxn ang="T119">
                        <a:pos x="T58" y="T59"/>
                      </a:cxn>
                      <a:cxn ang="T120">
                        <a:pos x="T60" y="T61"/>
                      </a:cxn>
                      <a:cxn ang="T121">
                        <a:pos x="T62" y="T63"/>
                      </a:cxn>
                      <a:cxn ang="T122">
                        <a:pos x="T64" y="T65"/>
                      </a:cxn>
                      <a:cxn ang="T123">
                        <a:pos x="T66" y="T67"/>
                      </a:cxn>
                      <a:cxn ang="T124">
                        <a:pos x="T68" y="T69"/>
                      </a:cxn>
                      <a:cxn ang="T125">
                        <a:pos x="T70" y="T71"/>
                      </a:cxn>
                      <a:cxn ang="T126">
                        <a:pos x="T72" y="T73"/>
                      </a:cxn>
                      <a:cxn ang="T127">
                        <a:pos x="T74" y="T75"/>
                      </a:cxn>
                      <a:cxn ang="T128">
                        <a:pos x="T76" y="T77"/>
                      </a:cxn>
                      <a:cxn ang="T129">
                        <a:pos x="T78" y="T79"/>
                      </a:cxn>
                      <a:cxn ang="T130">
                        <a:pos x="T80" y="T81"/>
                      </a:cxn>
                      <a:cxn ang="T131">
                        <a:pos x="T82" y="T83"/>
                      </a:cxn>
                      <a:cxn ang="T132">
                        <a:pos x="T84" y="T85"/>
                      </a:cxn>
                      <a:cxn ang="T133">
                        <a:pos x="T86" y="T87"/>
                      </a:cxn>
                      <a:cxn ang="T134">
                        <a:pos x="T88" y="T89"/>
                      </a:cxn>
                    </a:cxnLst>
                    <a:rect l="0" t="0" r="r" b="b"/>
                    <a:pathLst>
                      <a:path w="619" h="613">
                        <a:moveTo>
                          <a:pt x="619" y="167"/>
                        </a:moveTo>
                        <a:cubicBezTo>
                          <a:pt x="585" y="148"/>
                          <a:pt x="543" y="130"/>
                          <a:pt x="520" y="133"/>
                        </a:cubicBezTo>
                        <a:cubicBezTo>
                          <a:pt x="472" y="138"/>
                          <a:pt x="371" y="229"/>
                          <a:pt x="375" y="251"/>
                        </a:cubicBezTo>
                        <a:cubicBezTo>
                          <a:pt x="378" y="269"/>
                          <a:pt x="375" y="277"/>
                          <a:pt x="368" y="289"/>
                        </a:cubicBezTo>
                        <a:cubicBezTo>
                          <a:pt x="393" y="327"/>
                          <a:pt x="489" y="313"/>
                          <a:pt x="524" y="361"/>
                        </a:cubicBezTo>
                        <a:cubicBezTo>
                          <a:pt x="501" y="363"/>
                          <a:pt x="476" y="332"/>
                          <a:pt x="440" y="333"/>
                        </a:cubicBezTo>
                        <a:cubicBezTo>
                          <a:pt x="459" y="373"/>
                          <a:pt x="518" y="407"/>
                          <a:pt x="528" y="469"/>
                        </a:cubicBezTo>
                        <a:cubicBezTo>
                          <a:pt x="487" y="397"/>
                          <a:pt x="436" y="334"/>
                          <a:pt x="356" y="301"/>
                        </a:cubicBezTo>
                        <a:cubicBezTo>
                          <a:pt x="375" y="362"/>
                          <a:pt x="381" y="415"/>
                          <a:pt x="412" y="457"/>
                        </a:cubicBezTo>
                        <a:cubicBezTo>
                          <a:pt x="446" y="504"/>
                          <a:pt x="509" y="503"/>
                          <a:pt x="536" y="557"/>
                        </a:cubicBezTo>
                        <a:cubicBezTo>
                          <a:pt x="494" y="511"/>
                          <a:pt x="412" y="505"/>
                          <a:pt x="392" y="437"/>
                        </a:cubicBezTo>
                        <a:cubicBezTo>
                          <a:pt x="372" y="468"/>
                          <a:pt x="379" y="533"/>
                          <a:pt x="396" y="561"/>
                        </a:cubicBezTo>
                        <a:cubicBezTo>
                          <a:pt x="349" y="530"/>
                          <a:pt x="379" y="464"/>
                          <a:pt x="375" y="413"/>
                        </a:cubicBezTo>
                        <a:cubicBezTo>
                          <a:pt x="371" y="369"/>
                          <a:pt x="348" y="339"/>
                          <a:pt x="348" y="301"/>
                        </a:cubicBezTo>
                        <a:cubicBezTo>
                          <a:pt x="339" y="360"/>
                          <a:pt x="344" y="379"/>
                          <a:pt x="304" y="421"/>
                        </a:cubicBezTo>
                        <a:cubicBezTo>
                          <a:pt x="284" y="442"/>
                          <a:pt x="253" y="456"/>
                          <a:pt x="236" y="481"/>
                        </a:cubicBezTo>
                        <a:cubicBezTo>
                          <a:pt x="216" y="511"/>
                          <a:pt x="227" y="549"/>
                          <a:pt x="212" y="589"/>
                        </a:cubicBezTo>
                        <a:cubicBezTo>
                          <a:pt x="202" y="582"/>
                          <a:pt x="217" y="565"/>
                          <a:pt x="212" y="549"/>
                        </a:cubicBezTo>
                        <a:cubicBezTo>
                          <a:pt x="199" y="568"/>
                          <a:pt x="196" y="597"/>
                          <a:pt x="180" y="613"/>
                        </a:cubicBezTo>
                        <a:cubicBezTo>
                          <a:pt x="196" y="568"/>
                          <a:pt x="202" y="514"/>
                          <a:pt x="228" y="477"/>
                        </a:cubicBezTo>
                        <a:cubicBezTo>
                          <a:pt x="265" y="424"/>
                          <a:pt x="341" y="397"/>
                          <a:pt x="332" y="305"/>
                        </a:cubicBezTo>
                        <a:cubicBezTo>
                          <a:pt x="303" y="332"/>
                          <a:pt x="307" y="447"/>
                          <a:pt x="212" y="409"/>
                        </a:cubicBezTo>
                        <a:cubicBezTo>
                          <a:pt x="214" y="400"/>
                          <a:pt x="232" y="407"/>
                          <a:pt x="240" y="405"/>
                        </a:cubicBezTo>
                        <a:cubicBezTo>
                          <a:pt x="248" y="398"/>
                          <a:pt x="223" y="391"/>
                          <a:pt x="228" y="373"/>
                        </a:cubicBezTo>
                        <a:cubicBezTo>
                          <a:pt x="277" y="450"/>
                          <a:pt x="330" y="329"/>
                          <a:pt x="300" y="269"/>
                        </a:cubicBezTo>
                        <a:cubicBezTo>
                          <a:pt x="258" y="279"/>
                          <a:pt x="216" y="323"/>
                          <a:pt x="164" y="297"/>
                        </a:cubicBezTo>
                        <a:cubicBezTo>
                          <a:pt x="214" y="303"/>
                          <a:pt x="255" y="276"/>
                          <a:pt x="296" y="261"/>
                        </a:cubicBezTo>
                        <a:cubicBezTo>
                          <a:pt x="200" y="201"/>
                          <a:pt x="83" y="336"/>
                          <a:pt x="0" y="265"/>
                        </a:cubicBezTo>
                        <a:cubicBezTo>
                          <a:pt x="80" y="313"/>
                          <a:pt x="170" y="220"/>
                          <a:pt x="272" y="241"/>
                        </a:cubicBezTo>
                        <a:cubicBezTo>
                          <a:pt x="254" y="217"/>
                          <a:pt x="218" y="167"/>
                          <a:pt x="168" y="161"/>
                        </a:cubicBezTo>
                        <a:cubicBezTo>
                          <a:pt x="127" y="157"/>
                          <a:pt x="106" y="181"/>
                          <a:pt x="68" y="193"/>
                        </a:cubicBezTo>
                        <a:cubicBezTo>
                          <a:pt x="78" y="179"/>
                          <a:pt x="94" y="171"/>
                          <a:pt x="112" y="165"/>
                        </a:cubicBezTo>
                        <a:cubicBezTo>
                          <a:pt x="76" y="150"/>
                          <a:pt x="57" y="201"/>
                          <a:pt x="16" y="181"/>
                        </a:cubicBezTo>
                        <a:cubicBezTo>
                          <a:pt x="37" y="176"/>
                          <a:pt x="61" y="173"/>
                          <a:pt x="76" y="161"/>
                        </a:cubicBezTo>
                        <a:cubicBezTo>
                          <a:pt x="65" y="155"/>
                          <a:pt x="53" y="150"/>
                          <a:pt x="44" y="141"/>
                        </a:cubicBezTo>
                        <a:cubicBezTo>
                          <a:pt x="74" y="158"/>
                          <a:pt x="127" y="147"/>
                          <a:pt x="168" y="153"/>
                        </a:cubicBezTo>
                        <a:cubicBezTo>
                          <a:pt x="232" y="163"/>
                          <a:pt x="258" y="224"/>
                          <a:pt x="304" y="245"/>
                        </a:cubicBezTo>
                        <a:cubicBezTo>
                          <a:pt x="427" y="231"/>
                          <a:pt x="372" y="66"/>
                          <a:pt x="284" y="53"/>
                        </a:cubicBezTo>
                        <a:cubicBezTo>
                          <a:pt x="348" y="54"/>
                          <a:pt x="410" y="139"/>
                          <a:pt x="376" y="213"/>
                        </a:cubicBezTo>
                        <a:cubicBezTo>
                          <a:pt x="433" y="162"/>
                          <a:pt x="520" y="133"/>
                          <a:pt x="554" y="0"/>
                        </a:cubicBezTo>
                        <a:cubicBezTo>
                          <a:pt x="562" y="7"/>
                          <a:pt x="555" y="49"/>
                          <a:pt x="548" y="55"/>
                        </a:cubicBezTo>
                        <a:cubicBezTo>
                          <a:pt x="557" y="58"/>
                          <a:pt x="568" y="52"/>
                          <a:pt x="576" y="65"/>
                        </a:cubicBezTo>
                        <a:cubicBezTo>
                          <a:pt x="541" y="51"/>
                          <a:pt x="523" y="106"/>
                          <a:pt x="500" y="129"/>
                        </a:cubicBezTo>
                        <a:cubicBezTo>
                          <a:pt x="531" y="120"/>
                          <a:pt x="561" y="130"/>
                          <a:pt x="584" y="141"/>
                        </a:cubicBezTo>
                        <a:lnTo>
                          <a:pt x="619" y="167"/>
                        </a:lnTo>
                        <a:close/>
                      </a:path>
                    </a:pathLst>
                  </a:custGeom>
                  <a:solidFill>
                    <a:srgbClr val="23FF49"/>
                  </a:solidFill>
                  <a:ln w="6350" cap="flat">
                    <a:solidFill>
                      <a:srgbClr val="FF66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192" name="Oval 1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59" y="1834"/>
                    <a:ext cx="182" cy="193"/>
                  </a:xfrm>
                  <a:prstGeom prst="ellipse">
                    <a:avLst/>
                  </a:prstGeom>
                  <a:solidFill>
                    <a:srgbClr val="99CCFF"/>
                  </a:solidFill>
                  <a:ln w="6350">
                    <a:solidFill>
                      <a:srgbClr val="3366FF"/>
                    </a:solidFill>
                    <a:round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724" name="Group 10"/>
                <p:cNvGrpSpPr>
                  <a:grpSpLocks/>
                </p:cNvGrpSpPr>
                <p:nvPr/>
              </p:nvGrpSpPr>
              <p:grpSpPr bwMode="auto">
                <a:xfrm>
                  <a:off x="4387648" y="3010237"/>
                  <a:ext cx="362297" cy="535029"/>
                  <a:chOff x="1137" y="421"/>
                  <a:chExt cx="3501" cy="3467"/>
                </a:xfrm>
              </p:grpSpPr>
              <p:sp>
                <p:nvSpPr>
                  <p:cNvPr id="25728" name="Freeform 11"/>
                  <p:cNvSpPr>
                    <a:spLocks noChangeAspect="1"/>
                  </p:cNvSpPr>
                  <p:nvPr/>
                </p:nvSpPr>
                <p:spPr bwMode="auto">
                  <a:xfrm>
                    <a:off x="1137" y="421"/>
                    <a:ext cx="3501" cy="3467"/>
                  </a:xfrm>
                  <a:custGeom>
                    <a:avLst/>
                    <a:gdLst>
                      <a:gd name="T0" fmla="*/ 2147483647 w 619"/>
                      <a:gd name="T1" fmla="*/ 2147483647 h 613"/>
                      <a:gd name="T2" fmla="*/ 2147483647 w 619"/>
                      <a:gd name="T3" fmla="*/ 2147483647 h 613"/>
                      <a:gd name="T4" fmla="*/ 2147483647 w 619"/>
                      <a:gd name="T5" fmla="*/ 2147483647 h 613"/>
                      <a:gd name="T6" fmla="*/ 2147483647 w 619"/>
                      <a:gd name="T7" fmla="*/ 2147483647 h 613"/>
                      <a:gd name="T8" fmla="*/ 2147483647 w 619"/>
                      <a:gd name="T9" fmla="*/ 2147483647 h 613"/>
                      <a:gd name="T10" fmla="*/ 2147483647 w 619"/>
                      <a:gd name="T11" fmla="*/ 2147483647 h 613"/>
                      <a:gd name="T12" fmla="*/ 2147483647 w 619"/>
                      <a:gd name="T13" fmla="*/ 2147483647 h 613"/>
                      <a:gd name="T14" fmla="*/ 2147483647 w 619"/>
                      <a:gd name="T15" fmla="*/ 2147483647 h 613"/>
                      <a:gd name="T16" fmla="*/ 2147483647 w 619"/>
                      <a:gd name="T17" fmla="*/ 2147483647 h 613"/>
                      <a:gd name="T18" fmla="*/ 2147483647 w 619"/>
                      <a:gd name="T19" fmla="*/ 2147483647 h 613"/>
                      <a:gd name="T20" fmla="*/ 2147483647 w 619"/>
                      <a:gd name="T21" fmla="*/ 2147483647 h 613"/>
                      <a:gd name="T22" fmla="*/ 2147483647 w 619"/>
                      <a:gd name="T23" fmla="*/ 2147483647 h 613"/>
                      <a:gd name="T24" fmla="*/ 2147483647 w 619"/>
                      <a:gd name="T25" fmla="*/ 2147483647 h 613"/>
                      <a:gd name="T26" fmla="*/ 2147483647 w 619"/>
                      <a:gd name="T27" fmla="*/ 2147483647 h 613"/>
                      <a:gd name="T28" fmla="*/ 2147483647 w 619"/>
                      <a:gd name="T29" fmla="*/ 2147483647 h 613"/>
                      <a:gd name="T30" fmla="*/ 2147483647 w 619"/>
                      <a:gd name="T31" fmla="*/ 2147483647 h 613"/>
                      <a:gd name="T32" fmla="*/ 2147483647 w 619"/>
                      <a:gd name="T33" fmla="*/ 2147483647 h 613"/>
                      <a:gd name="T34" fmla="*/ 2147483647 w 619"/>
                      <a:gd name="T35" fmla="*/ 2147483647 h 613"/>
                      <a:gd name="T36" fmla="*/ 2147483647 w 619"/>
                      <a:gd name="T37" fmla="*/ 2147483647 h 613"/>
                      <a:gd name="T38" fmla="*/ 2147483647 w 619"/>
                      <a:gd name="T39" fmla="*/ 2147483647 h 613"/>
                      <a:gd name="T40" fmla="*/ 2147483647 w 619"/>
                      <a:gd name="T41" fmla="*/ 2147483647 h 613"/>
                      <a:gd name="T42" fmla="*/ 2147483647 w 619"/>
                      <a:gd name="T43" fmla="*/ 2147483647 h 613"/>
                      <a:gd name="T44" fmla="*/ 2147483647 w 619"/>
                      <a:gd name="T45" fmla="*/ 2147483647 h 613"/>
                      <a:gd name="T46" fmla="*/ 2147483647 w 619"/>
                      <a:gd name="T47" fmla="*/ 2147483647 h 613"/>
                      <a:gd name="T48" fmla="*/ 2147483647 w 619"/>
                      <a:gd name="T49" fmla="*/ 2147483647 h 613"/>
                      <a:gd name="T50" fmla="*/ 2147483647 w 619"/>
                      <a:gd name="T51" fmla="*/ 2147483647 h 613"/>
                      <a:gd name="T52" fmla="*/ 2147483647 w 619"/>
                      <a:gd name="T53" fmla="*/ 2147483647 h 613"/>
                      <a:gd name="T54" fmla="*/ 0 w 619"/>
                      <a:gd name="T55" fmla="*/ 2147483647 h 613"/>
                      <a:gd name="T56" fmla="*/ 2147483647 w 619"/>
                      <a:gd name="T57" fmla="*/ 2147483647 h 613"/>
                      <a:gd name="T58" fmla="*/ 2147483647 w 619"/>
                      <a:gd name="T59" fmla="*/ 2147483647 h 613"/>
                      <a:gd name="T60" fmla="*/ 2147483647 w 619"/>
                      <a:gd name="T61" fmla="*/ 2147483647 h 613"/>
                      <a:gd name="T62" fmla="*/ 2147483647 w 619"/>
                      <a:gd name="T63" fmla="*/ 2147483647 h 613"/>
                      <a:gd name="T64" fmla="*/ 2147483647 w 619"/>
                      <a:gd name="T65" fmla="*/ 2147483647 h 613"/>
                      <a:gd name="T66" fmla="*/ 2147483647 w 619"/>
                      <a:gd name="T67" fmla="*/ 2147483647 h 613"/>
                      <a:gd name="T68" fmla="*/ 2147483647 w 619"/>
                      <a:gd name="T69" fmla="*/ 2147483647 h 613"/>
                      <a:gd name="T70" fmla="*/ 2147483647 w 619"/>
                      <a:gd name="T71" fmla="*/ 2147483647 h 613"/>
                      <a:gd name="T72" fmla="*/ 2147483647 w 619"/>
                      <a:gd name="T73" fmla="*/ 2147483647 h 613"/>
                      <a:gd name="T74" fmla="*/ 2147483647 w 619"/>
                      <a:gd name="T75" fmla="*/ 2147483647 h 613"/>
                      <a:gd name="T76" fmla="*/ 2147483647 w 619"/>
                      <a:gd name="T77" fmla="*/ 2147483647 h 613"/>
                      <a:gd name="T78" fmla="*/ 2147483647 w 619"/>
                      <a:gd name="T79" fmla="*/ 0 h 613"/>
                      <a:gd name="T80" fmla="*/ 2147483647 w 619"/>
                      <a:gd name="T81" fmla="*/ 2147483647 h 613"/>
                      <a:gd name="T82" fmla="*/ 2147483647 w 619"/>
                      <a:gd name="T83" fmla="*/ 2147483647 h 613"/>
                      <a:gd name="T84" fmla="*/ 2147483647 w 619"/>
                      <a:gd name="T85" fmla="*/ 2147483647 h 613"/>
                      <a:gd name="T86" fmla="*/ 2147483647 w 619"/>
                      <a:gd name="T87" fmla="*/ 2147483647 h 613"/>
                      <a:gd name="T88" fmla="*/ 2147483647 w 619"/>
                      <a:gd name="T89" fmla="*/ 2147483647 h 613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</a:gdLst>
                    <a:ahLst/>
                    <a:cxnLst>
                      <a:cxn ang="T90">
                        <a:pos x="T0" y="T1"/>
                      </a:cxn>
                      <a:cxn ang="T91">
                        <a:pos x="T2" y="T3"/>
                      </a:cxn>
                      <a:cxn ang="T92">
                        <a:pos x="T4" y="T5"/>
                      </a:cxn>
                      <a:cxn ang="T93">
                        <a:pos x="T6" y="T7"/>
                      </a:cxn>
                      <a:cxn ang="T94">
                        <a:pos x="T8" y="T9"/>
                      </a:cxn>
                      <a:cxn ang="T95">
                        <a:pos x="T10" y="T11"/>
                      </a:cxn>
                      <a:cxn ang="T96">
                        <a:pos x="T12" y="T13"/>
                      </a:cxn>
                      <a:cxn ang="T97">
                        <a:pos x="T14" y="T15"/>
                      </a:cxn>
                      <a:cxn ang="T98">
                        <a:pos x="T16" y="T17"/>
                      </a:cxn>
                      <a:cxn ang="T99">
                        <a:pos x="T18" y="T19"/>
                      </a:cxn>
                      <a:cxn ang="T100">
                        <a:pos x="T20" y="T21"/>
                      </a:cxn>
                      <a:cxn ang="T101">
                        <a:pos x="T22" y="T23"/>
                      </a:cxn>
                      <a:cxn ang="T102">
                        <a:pos x="T24" y="T25"/>
                      </a:cxn>
                      <a:cxn ang="T103">
                        <a:pos x="T26" y="T27"/>
                      </a:cxn>
                      <a:cxn ang="T104">
                        <a:pos x="T28" y="T29"/>
                      </a:cxn>
                      <a:cxn ang="T105">
                        <a:pos x="T30" y="T31"/>
                      </a:cxn>
                      <a:cxn ang="T106">
                        <a:pos x="T32" y="T33"/>
                      </a:cxn>
                      <a:cxn ang="T107">
                        <a:pos x="T34" y="T35"/>
                      </a:cxn>
                      <a:cxn ang="T108">
                        <a:pos x="T36" y="T37"/>
                      </a:cxn>
                      <a:cxn ang="T109">
                        <a:pos x="T38" y="T39"/>
                      </a:cxn>
                      <a:cxn ang="T110">
                        <a:pos x="T40" y="T41"/>
                      </a:cxn>
                      <a:cxn ang="T111">
                        <a:pos x="T42" y="T43"/>
                      </a:cxn>
                      <a:cxn ang="T112">
                        <a:pos x="T44" y="T45"/>
                      </a:cxn>
                      <a:cxn ang="T113">
                        <a:pos x="T46" y="T47"/>
                      </a:cxn>
                      <a:cxn ang="T114">
                        <a:pos x="T48" y="T49"/>
                      </a:cxn>
                      <a:cxn ang="T115">
                        <a:pos x="T50" y="T51"/>
                      </a:cxn>
                      <a:cxn ang="T116">
                        <a:pos x="T52" y="T53"/>
                      </a:cxn>
                      <a:cxn ang="T117">
                        <a:pos x="T54" y="T55"/>
                      </a:cxn>
                      <a:cxn ang="T118">
                        <a:pos x="T56" y="T57"/>
                      </a:cxn>
                      <a:cxn ang="T119">
                        <a:pos x="T58" y="T59"/>
                      </a:cxn>
                      <a:cxn ang="T120">
                        <a:pos x="T60" y="T61"/>
                      </a:cxn>
                      <a:cxn ang="T121">
                        <a:pos x="T62" y="T63"/>
                      </a:cxn>
                      <a:cxn ang="T122">
                        <a:pos x="T64" y="T65"/>
                      </a:cxn>
                      <a:cxn ang="T123">
                        <a:pos x="T66" y="T67"/>
                      </a:cxn>
                      <a:cxn ang="T124">
                        <a:pos x="T68" y="T69"/>
                      </a:cxn>
                      <a:cxn ang="T125">
                        <a:pos x="T70" y="T71"/>
                      </a:cxn>
                      <a:cxn ang="T126">
                        <a:pos x="T72" y="T73"/>
                      </a:cxn>
                      <a:cxn ang="T127">
                        <a:pos x="T74" y="T75"/>
                      </a:cxn>
                      <a:cxn ang="T128">
                        <a:pos x="T76" y="T77"/>
                      </a:cxn>
                      <a:cxn ang="T129">
                        <a:pos x="T78" y="T79"/>
                      </a:cxn>
                      <a:cxn ang="T130">
                        <a:pos x="T80" y="T81"/>
                      </a:cxn>
                      <a:cxn ang="T131">
                        <a:pos x="T82" y="T83"/>
                      </a:cxn>
                      <a:cxn ang="T132">
                        <a:pos x="T84" y="T85"/>
                      </a:cxn>
                      <a:cxn ang="T133">
                        <a:pos x="T86" y="T87"/>
                      </a:cxn>
                      <a:cxn ang="T134">
                        <a:pos x="T88" y="T89"/>
                      </a:cxn>
                    </a:cxnLst>
                    <a:rect l="0" t="0" r="r" b="b"/>
                    <a:pathLst>
                      <a:path w="619" h="613">
                        <a:moveTo>
                          <a:pt x="619" y="167"/>
                        </a:moveTo>
                        <a:cubicBezTo>
                          <a:pt x="585" y="148"/>
                          <a:pt x="543" y="130"/>
                          <a:pt x="520" y="133"/>
                        </a:cubicBezTo>
                        <a:cubicBezTo>
                          <a:pt x="472" y="138"/>
                          <a:pt x="371" y="229"/>
                          <a:pt x="375" y="251"/>
                        </a:cubicBezTo>
                        <a:cubicBezTo>
                          <a:pt x="378" y="269"/>
                          <a:pt x="375" y="277"/>
                          <a:pt x="368" y="289"/>
                        </a:cubicBezTo>
                        <a:cubicBezTo>
                          <a:pt x="393" y="327"/>
                          <a:pt x="489" y="313"/>
                          <a:pt x="524" y="361"/>
                        </a:cubicBezTo>
                        <a:cubicBezTo>
                          <a:pt x="501" y="363"/>
                          <a:pt x="476" y="332"/>
                          <a:pt x="440" y="333"/>
                        </a:cubicBezTo>
                        <a:cubicBezTo>
                          <a:pt x="459" y="373"/>
                          <a:pt x="518" y="407"/>
                          <a:pt x="528" y="469"/>
                        </a:cubicBezTo>
                        <a:cubicBezTo>
                          <a:pt x="487" y="397"/>
                          <a:pt x="436" y="334"/>
                          <a:pt x="356" y="301"/>
                        </a:cubicBezTo>
                        <a:cubicBezTo>
                          <a:pt x="375" y="362"/>
                          <a:pt x="381" y="415"/>
                          <a:pt x="412" y="457"/>
                        </a:cubicBezTo>
                        <a:cubicBezTo>
                          <a:pt x="446" y="504"/>
                          <a:pt x="509" y="503"/>
                          <a:pt x="536" y="557"/>
                        </a:cubicBezTo>
                        <a:cubicBezTo>
                          <a:pt x="494" y="511"/>
                          <a:pt x="412" y="505"/>
                          <a:pt x="392" y="437"/>
                        </a:cubicBezTo>
                        <a:cubicBezTo>
                          <a:pt x="372" y="468"/>
                          <a:pt x="379" y="533"/>
                          <a:pt x="396" y="561"/>
                        </a:cubicBezTo>
                        <a:cubicBezTo>
                          <a:pt x="349" y="530"/>
                          <a:pt x="379" y="464"/>
                          <a:pt x="375" y="413"/>
                        </a:cubicBezTo>
                        <a:cubicBezTo>
                          <a:pt x="371" y="369"/>
                          <a:pt x="348" y="339"/>
                          <a:pt x="348" y="301"/>
                        </a:cubicBezTo>
                        <a:cubicBezTo>
                          <a:pt x="339" y="360"/>
                          <a:pt x="344" y="379"/>
                          <a:pt x="304" y="421"/>
                        </a:cubicBezTo>
                        <a:cubicBezTo>
                          <a:pt x="284" y="442"/>
                          <a:pt x="253" y="456"/>
                          <a:pt x="236" y="481"/>
                        </a:cubicBezTo>
                        <a:cubicBezTo>
                          <a:pt x="216" y="511"/>
                          <a:pt x="227" y="549"/>
                          <a:pt x="212" y="589"/>
                        </a:cubicBezTo>
                        <a:cubicBezTo>
                          <a:pt x="202" y="582"/>
                          <a:pt x="217" y="565"/>
                          <a:pt x="212" y="549"/>
                        </a:cubicBezTo>
                        <a:cubicBezTo>
                          <a:pt x="199" y="568"/>
                          <a:pt x="196" y="597"/>
                          <a:pt x="180" y="613"/>
                        </a:cubicBezTo>
                        <a:cubicBezTo>
                          <a:pt x="196" y="568"/>
                          <a:pt x="202" y="514"/>
                          <a:pt x="228" y="477"/>
                        </a:cubicBezTo>
                        <a:cubicBezTo>
                          <a:pt x="265" y="424"/>
                          <a:pt x="341" y="397"/>
                          <a:pt x="332" y="305"/>
                        </a:cubicBezTo>
                        <a:cubicBezTo>
                          <a:pt x="303" y="332"/>
                          <a:pt x="307" y="447"/>
                          <a:pt x="212" y="409"/>
                        </a:cubicBezTo>
                        <a:cubicBezTo>
                          <a:pt x="214" y="400"/>
                          <a:pt x="232" y="407"/>
                          <a:pt x="240" y="405"/>
                        </a:cubicBezTo>
                        <a:cubicBezTo>
                          <a:pt x="248" y="398"/>
                          <a:pt x="223" y="391"/>
                          <a:pt x="228" y="373"/>
                        </a:cubicBezTo>
                        <a:cubicBezTo>
                          <a:pt x="277" y="450"/>
                          <a:pt x="330" y="329"/>
                          <a:pt x="300" y="269"/>
                        </a:cubicBezTo>
                        <a:cubicBezTo>
                          <a:pt x="258" y="279"/>
                          <a:pt x="216" y="323"/>
                          <a:pt x="164" y="297"/>
                        </a:cubicBezTo>
                        <a:cubicBezTo>
                          <a:pt x="214" y="303"/>
                          <a:pt x="255" y="276"/>
                          <a:pt x="296" y="261"/>
                        </a:cubicBezTo>
                        <a:cubicBezTo>
                          <a:pt x="200" y="201"/>
                          <a:pt x="83" y="336"/>
                          <a:pt x="0" y="265"/>
                        </a:cubicBezTo>
                        <a:cubicBezTo>
                          <a:pt x="80" y="313"/>
                          <a:pt x="170" y="220"/>
                          <a:pt x="272" y="241"/>
                        </a:cubicBezTo>
                        <a:cubicBezTo>
                          <a:pt x="254" y="217"/>
                          <a:pt x="218" y="167"/>
                          <a:pt x="168" y="161"/>
                        </a:cubicBezTo>
                        <a:cubicBezTo>
                          <a:pt x="127" y="157"/>
                          <a:pt x="106" y="181"/>
                          <a:pt x="68" y="193"/>
                        </a:cubicBezTo>
                        <a:cubicBezTo>
                          <a:pt x="78" y="179"/>
                          <a:pt x="94" y="171"/>
                          <a:pt x="112" y="165"/>
                        </a:cubicBezTo>
                        <a:cubicBezTo>
                          <a:pt x="76" y="150"/>
                          <a:pt x="57" y="201"/>
                          <a:pt x="16" y="181"/>
                        </a:cubicBezTo>
                        <a:cubicBezTo>
                          <a:pt x="37" y="176"/>
                          <a:pt x="61" y="173"/>
                          <a:pt x="76" y="161"/>
                        </a:cubicBezTo>
                        <a:cubicBezTo>
                          <a:pt x="65" y="155"/>
                          <a:pt x="53" y="150"/>
                          <a:pt x="44" y="141"/>
                        </a:cubicBezTo>
                        <a:cubicBezTo>
                          <a:pt x="74" y="158"/>
                          <a:pt x="127" y="147"/>
                          <a:pt x="168" y="153"/>
                        </a:cubicBezTo>
                        <a:cubicBezTo>
                          <a:pt x="232" y="163"/>
                          <a:pt x="258" y="224"/>
                          <a:pt x="304" y="245"/>
                        </a:cubicBezTo>
                        <a:cubicBezTo>
                          <a:pt x="427" y="231"/>
                          <a:pt x="372" y="66"/>
                          <a:pt x="284" y="53"/>
                        </a:cubicBezTo>
                        <a:cubicBezTo>
                          <a:pt x="348" y="54"/>
                          <a:pt x="410" y="139"/>
                          <a:pt x="376" y="213"/>
                        </a:cubicBezTo>
                        <a:cubicBezTo>
                          <a:pt x="433" y="162"/>
                          <a:pt x="520" y="133"/>
                          <a:pt x="554" y="0"/>
                        </a:cubicBezTo>
                        <a:cubicBezTo>
                          <a:pt x="562" y="7"/>
                          <a:pt x="555" y="49"/>
                          <a:pt x="548" y="55"/>
                        </a:cubicBezTo>
                        <a:cubicBezTo>
                          <a:pt x="557" y="58"/>
                          <a:pt x="568" y="52"/>
                          <a:pt x="576" y="65"/>
                        </a:cubicBezTo>
                        <a:cubicBezTo>
                          <a:pt x="541" y="51"/>
                          <a:pt x="523" y="106"/>
                          <a:pt x="500" y="129"/>
                        </a:cubicBezTo>
                        <a:cubicBezTo>
                          <a:pt x="531" y="120"/>
                          <a:pt x="561" y="130"/>
                          <a:pt x="584" y="141"/>
                        </a:cubicBezTo>
                        <a:lnTo>
                          <a:pt x="619" y="167"/>
                        </a:lnTo>
                        <a:close/>
                      </a:path>
                    </a:pathLst>
                  </a:custGeom>
                  <a:solidFill>
                    <a:srgbClr val="23FF49"/>
                  </a:solidFill>
                  <a:ln w="6350" cap="flat">
                    <a:solidFill>
                      <a:srgbClr val="FF66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190" name="Oval 1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58" y="1828"/>
                    <a:ext cx="182" cy="193"/>
                  </a:xfrm>
                  <a:prstGeom prst="ellipse">
                    <a:avLst/>
                  </a:prstGeom>
                  <a:solidFill>
                    <a:srgbClr val="99CCFF"/>
                  </a:solidFill>
                  <a:ln w="6350">
                    <a:solidFill>
                      <a:srgbClr val="3366FF"/>
                    </a:solidFill>
                    <a:round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725" name="Group 10"/>
                <p:cNvGrpSpPr>
                  <a:grpSpLocks/>
                </p:cNvGrpSpPr>
                <p:nvPr/>
              </p:nvGrpSpPr>
              <p:grpSpPr bwMode="auto">
                <a:xfrm>
                  <a:off x="3404612" y="2878020"/>
                  <a:ext cx="362297" cy="535029"/>
                  <a:chOff x="1137" y="421"/>
                  <a:chExt cx="3501" cy="3467"/>
                </a:xfrm>
              </p:grpSpPr>
              <p:sp>
                <p:nvSpPr>
                  <p:cNvPr id="25726" name="Freeform 11"/>
                  <p:cNvSpPr>
                    <a:spLocks noChangeAspect="1"/>
                  </p:cNvSpPr>
                  <p:nvPr/>
                </p:nvSpPr>
                <p:spPr bwMode="auto">
                  <a:xfrm>
                    <a:off x="1137" y="421"/>
                    <a:ext cx="3501" cy="3467"/>
                  </a:xfrm>
                  <a:custGeom>
                    <a:avLst/>
                    <a:gdLst>
                      <a:gd name="T0" fmla="*/ 2147483647 w 619"/>
                      <a:gd name="T1" fmla="*/ 2147483647 h 613"/>
                      <a:gd name="T2" fmla="*/ 2147483647 w 619"/>
                      <a:gd name="T3" fmla="*/ 2147483647 h 613"/>
                      <a:gd name="T4" fmla="*/ 2147483647 w 619"/>
                      <a:gd name="T5" fmla="*/ 2147483647 h 613"/>
                      <a:gd name="T6" fmla="*/ 2147483647 w 619"/>
                      <a:gd name="T7" fmla="*/ 2147483647 h 613"/>
                      <a:gd name="T8" fmla="*/ 2147483647 w 619"/>
                      <a:gd name="T9" fmla="*/ 2147483647 h 613"/>
                      <a:gd name="T10" fmla="*/ 2147483647 w 619"/>
                      <a:gd name="T11" fmla="*/ 2147483647 h 613"/>
                      <a:gd name="T12" fmla="*/ 2147483647 w 619"/>
                      <a:gd name="T13" fmla="*/ 2147483647 h 613"/>
                      <a:gd name="T14" fmla="*/ 2147483647 w 619"/>
                      <a:gd name="T15" fmla="*/ 2147483647 h 613"/>
                      <a:gd name="T16" fmla="*/ 2147483647 w 619"/>
                      <a:gd name="T17" fmla="*/ 2147483647 h 613"/>
                      <a:gd name="T18" fmla="*/ 2147483647 w 619"/>
                      <a:gd name="T19" fmla="*/ 2147483647 h 613"/>
                      <a:gd name="T20" fmla="*/ 2147483647 w 619"/>
                      <a:gd name="T21" fmla="*/ 2147483647 h 613"/>
                      <a:gd name="T22" fmla="*/ 2147483647 w 619"/>
                      <a:gd name="T23" fmla="*/ 2147483647 h 613"/>
                      <a:gd name="T24" fmla="*/ 2147483647 w 619"/>
                      <a:gd name="T25" fmla="*/ 2147483647 h 613"/>
                      <a:gd name="T26" fmla="*/ 2147483647 w 619"/>
                      <a:gd name="T27" fmla="*/ 2147483647 h 613"/>
                      <a:gd name="T28" fmla="*/ 2147483647 w 619"/>
                      <a:gd name="T29" fmla="*/ 2147483647 h 613"/>
                      <a:gd name="T30" fmla="*/ 2147483647 w 619"/>
                      <a:gd name="T31" fmla="*/ 2147483647 h 613"/>
                      <a:gd name="T32" fmla="*/ 2147483647 w 619"/>
                      <a:gd name="T33" fmla="*/ 2147483647 h 613"/>
                      <a:gd name="T34" fmla="*/ 2147483647 w 619"/>
                      <a:gd name="T35" fmla="*/ 2147483647 h 613"/>
                      <a:gd name="T36" fmla="*/ 2147483647 w 619"/>
                      <a:gd name="T37" fmla="*/ 2147483647 h 613"/>
                      <a:gd name="T38" fmla="*/ 2147483647 w 619"/>
                      <a:gd name="T39" fmla="*/ 2147483647 h 613"/>
                      <a:gd name="T40" fmla="*/ 2147483647 w 619"/>
                      <a:gd name="T41" fmla="*/ 2147483647 h 613"/>
                      <a:gd name="T42" fmla="*/ 2147483647 w 619"/>
                      <a:gd name="T43" fmla="*/ 2147483647 h 613"/>
                      <a:gd name="T44" fmla="*/ 2147483647 w 619"/>
                      <a:gd name="T45" fmla="*/ 2147483647 h 613"/>
                      <a:gd name="T46" fmla="*/ 2147483647 w 619"/>
                      <a:gd name="T47" fmla="*/ 2147483647 h 613"/>
                      <a:gd name="T48" fmla="*/ 2147483647 w 619"/>
                      <a:gd name="T49" fmla="*/ 2147483647 h 613"/>
                      <a:gd name="T50" fmla="*/ 2147483647 w 619"/>
                      <a:gd name="T51" fmla="*/ 2147483647 h 613"/>
                      <a:gd name="T52" fmla="*/ 2147483647 w 619"/>
                      <a:gd name="T53" fmla="*/ 2147483647 h 613"/>
                      <a:gd name="T54" fmla="*/ 0 w 619"/>
                      <a:gd name="T55" fmla="*/ 2147483647 h 613"/>
                      <a:gd name="T56" fmla="*/ 2147483647 w 619"/>
                      <a:gd name="T57" fmla="*/ 2147483647 h 613"/>
                      <a:gd name="T58" fmla="*/ 2147483647 w 619"/>
                      <a:gd name="T59" fmla="*/ 2147483647 h 613"/>
                      <a:gd name="T60" fmla="*/ 2147483647 w 619"/>
                      <a:gd name="T61" fmla="*/ 2147483647 h 613"/>
                      <a:gd name="T62" fmla="*/ 2147483647 w 619"/>
                      <a:gd name="T63" fmla="*/ 2147483647 h 613"/>
                      <a:gd name="T64" fmla="*/ 2147483647 w 619"/>
                      <a:gd name="T65" fmla="*/ 2147483647 h 613"/>
                      <a:gd name="T66" fmla="*/ 2147483647 w 619"/>
                      <a:gd name="T67" fmla="*/ 2147483647 h 613"/>
                      <a:gd name="T68" fmla="*/ 2147483647 w 619"/>
                      <a:gd name="T69" fmla="*/ 2147483647 h 613"/>
                      <a:gd name="T70" fmla="*/ 2147483647 w 619"/>
                      <a:gd name="T71" fmla="*/ 2147483647 h 613"/>
                      <a:gd name="T72" fmla="*/ 2147483647 w 619"/>
                      <a:gd name="T73" fmla="*/ 2147483647 h 613"/>
                      <a:gd name="T74" fmla="*/ 2147483647 w 619"/>
                      <a:gd name="T75" fmla="*/ 2147483647 h 613"/>
                      <a:gd name="T76" fmla="*/ 2147483647 w 619"/>
                      <a:gd name="T77" fmla="*/ 2147483647 h 613"/>
                      <a:gd name="T78" fmla="*/ 2147483647 w 619"/>
                      <a:gd name="T79" fmla="*/ 0 h 613"/>
                      <a:gd name="T80" fmla="*/ 2147483647 w 619"/>
                      <a:gd name="T81" fmla="*/ 2147483647 h 613"/>
                      <a:gd name="T82" fmla="*/ 2147483647 w 619"/>
                      <a:gd name="T83" fmla="*/ 2147483647 h 613"/>
                      <a:gd name="T84" fmla="*/ 2147483647 w 619"/>
                      <a:gd name="T85" fmla="*/ 2147483647 h 613"/>
                      <a:gd name="T86" fmla="*/ 2147483647 w 619"/>
                      <a:gd name="T87" fmla="*/ 2147483647 h 613"/>
                      <a:gd name="T88" fmla="*/ 2147483647 w 619"/>
                      <a:gd name="T89" fmla="*/ 2147483647 h 613"/>
                      <a:gd name="T90" fmla="*/ 0 60000 65536"/>
                      <a:gd name="T91" fmla="*/ 0 60000 65536"/>
                      <a:gd name="T92" fmla="*/ 0 60000 65536"/>
                      <a:gd name="T93" fmla="*/ 0 60000 65536"/>
                      <a:gd name="T94" fmla="*/ 0 60000 65536"/>
                      <a:gd name="T95" fmla="*/ 0 60000 65536"/>
                      <a:gd name="T96" fmla="*/ 0 60000 65536"/>
                      <a:gd name="T97" fmla="*/ 0 60000 65536"/>
                      <a:gd name="T98" fmla="*/ 0 60000 65536"/>
                      <a:gd name="T99" fmla="*/ 0 60000 65536"/>
                      <a:gd name="T100" fmla="*/ 0 60000 65536"/>
                      <a:gd name="T101" fmla="*/ 0 60000 65536"/>
                      <a:gd name="T102" fmla="*/ 0 60000 65536"/>
                      <a:gd name="T103" fmla="*/ 0 60000 65536"/>
                      <a:gd name="T104" fmla="*/ 0 60000 65536"/>
                      <a:gd name="T105" fmla="*/ 0 60000 65536"/>
                      <a:gd name="T106" fmla="*/ 0 60000 65536"/>
                      <a:gd name="T107" fmla="*/ 0 60000 65536"/>
                      <a:gd name="T108" fmla="*/ 0 60000 65536"/>
                      <a:gd name="T109" fmla="*/ 0 60000 65536"/>
                      <a:gd name="T110" fmla="*/ 0 60000 65536"/>
                      <a:gd name="T111" fmla="*/ 0 60000 65536"/>
                      <a:gd name="T112" fmla="*/ 0 60000 65536"/>
                      <a:gd name="T113" fmla="*/ 0 60000 65536"/>
                      <a:gd name="T114" fmla="*/ 0 60000 65536"/>
                      <a:gd name="T115" fmla="*/ 0 60000 65536"/>
                      <a:gd name="T116" fmla="*/ 0 60000 65536"/>
                      <a:gd name="T117" fmla="*/ 0 60000 65536"/>
                      <a:gd name="T118" fmla="*/ 0 60000 65536"/>
                      <a:gd name="T119" fmla="*/ 0 60000 65536"/>
                      <a:gd name="T120" fmla="*/ 0 60000 65536"/>
                      <a:gd name="T121" fmla="*/ 0 60000 65536"/>
                      <a:gd name="T122" fmla="*/ 0 60000 65536"/>
                      <a:gd name="T123" fmla="*/ 0 60000 65536"/>
                      <a:gd name="T124" fmla="*/ 0 60000 65536"/>
                      <a:gd name="T125" fmla="*/ 0 60000 65536"/>
                      <a:gd name="T126" fmla="*/ 0 60000 65536"/>
                      <a:gd name="T127" fmla="*/ 0 60000 65536"/>
                      <a:gd name="T128" fmla="*/ 0 60000 65536"/>
                      <a:gd name="T129" fmla="*/ 0 60000 65536"/>
                      <a:gd name="T130" fmla="*/ 0 60000 65536"/>
                      <a:gd name="T131" fmla="*/ 0 60000 65536"/>
                      <a:gd name="T132" fmla="*/ 0 60000 65536"/>
                      <a:gd name="T133" fmla="*/ 0 60000 65536"/>
                      <a:gd name="T134" fmla="*/ 0 60000 65536"/>
                    </a:gdLst>
                    <a:ahLst/>
                    <a:cxnLst>
                      <a:cxn ang="T90">
                        <a:pos x="T0" y="T1"/>
                      </a:cxn>
                      <a:cxn ang="T91">
                        <a:pos x="T2" y="T3"/>
                      </a:cxn>
                      <a:cxn ang="T92">
                        <a:pos x="T4" y="T5"/>
                      </a:cxn>
                      <a:cxn ang="T93">
                        <a:pos x="T6" y="T7"/>
                      </a:cxn>
                      <a:cxn ang="T94">
                        <a:pos x="T8" y="T9"/>
                      </a:cxn>
                      <a:cxn ang="T95">
                        <a:pos x="T10" y="T11"/>
                      </a:cxn>
                      <a:cxn ang="T96">
                        <a:pos x="T12" y="T13"/>
                      </a:cxn>
                      <a:cxn ang="T97">
                        <a:pos x="T14" y="T15"/>
                      </a:cxn>
                      <a:cxn ang="T98">
                        <a:pos x="T16" y="T17"/>
                      </a:cxn>
                      <a:cxn ang="T99">
                        <a:pos x="T18" y="T19"/>
                      </a:cxn>
                      <a:cxn ang="T100">
                        <a:pos x="T20" y="T21"/>
                      </a:cxn>
                      <a:cxn ang="T101">
                        <a:pos x="T22" y="T23"/>
                      </a:cxn>
                      <a:cxn ang="T102">
                        <a:pos x="T24" y="T25"/>
                      </a:cxn>
                      <a:cxn ang="T103">
                        <a:pos x="T26" y="T27"/>
                      </a:cxn>
                      <a:cxn ang="T104">
                        <a:pos x="T28" y="T29"/>
                      </a:cxn>
                      <a:cxn ang="T105">
                        <a:pos x="T30" y="T31"/>
                      </a:cxn>
                      <a:cxn ang="T106">
                        <a:pos x="T32" y="T33"/>
                      </a:cxn>
                      <a:cxn ang="T107">
                        <a:pos x="T34" y="T35"/>
                      </a:cxn>
                      <a:cxn ang="T108">
                        <a:pos x="T36" y="T37"/>
                      </a:cxn>
                      <a:cxn ang="T109">
                        <a:pos x="T38" y="T39"/>
                      </a:cxn>
                      <a:cxn ang="T110">
                        <a:pos x="T40" y="T41"/>
                      </a:cxn>
                      <a:cxn ang="T111">
                        <a:pos x="T42" y="T43"/>
                      </a:cxn>
                      <a:cxn ang="T112">
                        <a:pos x="T44" y="T45"/>
                      </a:cxn>
                      <a:cxn ang="T113">
                        <a:pos x="T46" y="T47"/>
                      </a:cxn>
                      <a:cxn ang="T114">
                        <a:pos x="T48" y="T49"/>
                      </a:cxn>
                      <a:cxn ang="T115">
                        <a:pos x="T50" y="T51"/>
                      </a:cxn>
                      <a:cxn ang="T116">
                        <a:pos x="T52" y="T53"/>
                      </a:cxn>
                      <a:cxn ang="T117">
                        <a:pos x="T54" y="T55"/>
                      </a:cxn>
                      <a:cxn ang="T118">
                        <a:pos x="T56" y="T57"/>
                      </a:cxn>
                      <a:cxn ang="T119">
                        <a:pos x="T58" y="T59"/>
                      </a:cxn>
                      <a:cxn ang="T120">
                        <a:pos x="T60" y="T61"/>
                      </a:cxn>
                      <a:cxn ang="T121">
                        <a:pos x="T62" y="T63"/>
                      </a:cxn>
                      <a:cxn ang="T122">
                        <a:pos x="T64" y="T65"/>
                      </a:cxn>
                      <a:cxn ang="T123">
                        <a:pos x="T66" y="T67"/>
                      </a:cxn>
                      <a:cxn ang="T124">
                        <a:pos x="T68" y="T69"/>
                      </a:cxn>
                      <a:cxn ang="T125">
                        <a:pos x="T70" y="T71"/>
                      </a:cxn>
                      <a:cxn ang="T126">
                        <a:pos x="T72" y="T73"/>
                      </a:cxn>
                      <a:cxn ang="T127">
                        <a:pos x="T74" y="T75"/>
                      </a:cxn>
                      <a:cxn ang="T128">
                        <a:pos x="T76" y="T77"/>
                      </a:cxn>
                      <a:cxn ang="T129">
                        <a:pos x="T78" y="T79"/>
                      </a:cxn>
                      <a:cxn ang="T130">
                        <a:pos x="T80" y="T81"/>
                      </a:cxn>
                      <a:cxn ang="T131">
                        <a:pos x="T82" y="T83"/>
                      </a:cxn>
                      <a:cxn ang="T132">
                        <a:pos x="T84" y="T85"/>
                      </a:cxn>
                      <a:cxn ang="T133">
                        <a:pos x="T86" y="T87"/>
                      </a:cxn>
                      <a:cxn ang="T134">
                        <a:pos x="T88" y="T89"/>
                      </a:cxn>
                    </a:cxnLst>
                    <a:rect l="0" t="0" r="r" b="b"/>
                    <a:pathLst>
                      <a:path w="619" h="613">
                        <a:moveTo>
                          <a:pt x="619" y="167"/>
                        </a:moveTo>
                        <a:cubicBezTo>
                          <a:pt x="585" y="148"/>
                          <a:pt x="543" y="130"/>
                          <a:pt x="520" y="133"/>
                        </a:cubicBezTo>
                        <a:cubicBezTo>
                          <a:pt x="472" y="138"/>
                          <a:pt x="371" y="229"/>
                          <a:pt x="375" y="251"/>
                        </a:cubicBezTo>
                        <a:cubicBezTo>
                          <a:pt x="378" y="269"/>
                          <a:pt x="375" y="277"/>
                          <a:pt x="368" y="289"/>
                        </a:cubicBezTo>
                        <a:cubicBezTo>
                          <a:pt x="393" y="327"/>
                          <a:pt x="489" y="313"/>
                          <a:pt x="524" y="361"/>
                        </a:cubicBezTo>
                        <a:cubicBezTo>
                          <a:pt x="501" y="363"/>
                          <a:pt x="476" y="332"/>
                          <a:pt x="440" y="333"/>
                        </a:cubicBezTo>
                        <a:cubicBezTo>
                          <a:pt x="459" y="373"/>
                          <a:pt x="518" y="407"/>
                          <a:pt x="528" y="469"/>
                        </a:cubicBezTo>
                        <a:cubicBezTo>
                          <a:pt x="487" y="397"/>
                          <a:pt x="436" y="334"/>
                          <a:pt x="356" y="301"/>
                        </a:cubicBezTo>
                        <a:cubicBezTo>
                          <a:pt x="375" y="362"/>
                          <a:pt x="381" y="415"/>
                          <a:pt x="412" y="457"/>
                        </a:cubicBezTo>
                        <a:cubicBezTo>
                          <a:pt x="446" y="504"/>
                          <a:pt x="509" y="503"/>
                          <a:pt x="536" y="557"/>
                        </a:cubicBezTo>
                        <a:cubicBezTo>
                          <a:pt x="494" y="511"/>
                          <a:pt x="412" y="505"/>
                          <a:pt x="392" y="437"/>
                        </a:cubicBezTo>
                        <a:cubicBezTo>
                          <a:pt x="372" y="468"/>
                          <a:pt x="379" y="533"/>
                          <a:pt x="396" y="561"/>
                        </a:cubicBezTo>
                        <a:cubicBezTo>
                          <a:pt x="349" y="530"/>
                          <a:pt x="379" y="464"/>
                          <a:pt x="375" y="413"/>
                        </a:cubicBezTo>
                        <a:cubicBezTo>
                          <a:pt x="371" y="369"/>
                          <a:pt x="348" y="339"/>
                          <a:pt x="348" y="301"/>
                        </a:cubicBezTo>
                        <a:cubicBezTo>
                          <a:pt x="339" y="360"/>
                          <a:pt x="344" y="379"/>
                          <a:pt x="304" y="421"/>
                        </a:cubicBezTo>
                        <a:cubicBezTo>
                          <a:pt x="284" y="442"/>
                          <a:pt x="253" y="456"/>
                          <a:pt x="236" y="481"/>
                        </a:cubicBezTo>
                        <a:cubicBezTo>
                          <a:pt x="216" y="511"/>
                          <a:pt x="227" y="549"/>
                          <a:pt x="212" y="589"/>
                        </a:cubicBezTo>
                        <a:cubicBezTo>
                          <a:pt x="202" y="582"/>
                          <a:pt x="217" y="565"/>
                          <a:pt x="212" y="549"/>
                        </a:cubicBezTo>
                        <a:cubicBezTo>
                          <a:pt x="199" y="568"/>
                          <a:pt x="196" y="597"/>
                          <a:pt x="180" y="613"/>
                        </a:cubicBezTo>
                        <a:cubicBezTo>
                          <a:pt x="196" y="568"/>
                          <a:pt x="202" y="514"/>
                          <a:pt x="228" y="477"/>
                        </a:cubicBezTo>
                        <a:cubicBezTo>
                          <a:pt x="265" y="424"/>
                          <a:pt x="341" y="397"/>
                          <a:pt x="332" y="305"/>
                        </a:cubicBezTo>
                        <a:cubicBezTo>
                          <a:pt x="303" y="332"/>
                          <a:pt x="307" y="447"/>
                          <a:pt x="212" y="409"/>
                        </a:cubicBezTo>
                        <a:cubicBezTo>
                          <a:pt x="214" y="400"/>
                          <a:pt x="232" y="407"/>
                          <a:pt x="240" y="405"/>
                        </a:cubicBezTo>
                        <a:cubicBezTo>
                          <a:pt x="248" y="398"/>
                          <a:pt x="223" y="391"/>
                          <a:pt x="228" y="373"/>
                        </a:cubicBezTo>
                        <a:cubicBezTo>
                          <a:pt x="277" y="450"/>
                          <a:pt x="330" y="329"/>
                          <a:pt x="300" y="269"/>
                        </a:cubicBezTo>
                        <a:cubicBezTo>
                          <a:pt x="258" y="279"/>
                          <a:pt x="216" y="323"/>
                          <a:pt x="164" y="297"/>
                        </a:cubicBezTo>
                        <a:cubicBezTo>
                          <a:pt x="214" y="303"/>
                          <a:pt x="255" y="276"/>
                          <a:pt x="296" y="261"/>
                        </a:cubicBezTo>
                        <a:cubicBezTo>
                          <a:pt x="200" y="201"/>
                          <a:pt x="83" y="336"/>
                          <a:pt x="0" y="265"/>
                        </a:cubicBezTo>
                        <a:cubicBezTo>
                          <a:pt x="80" y="313"/>
                          <a:pt x="170" y="220"/>
                          <a:pt x="272" y="241"/>
                        </a:cubicBezTo>
                        <a:cubicBezTo>
                          <a:pt x="254" y="217"/>
                          <a:pt x="218" y="167"/>
                          <a:pt x="168" y="161"/>
                        </a:cubicBezTo>
                        <a:cubicBezTo>
                          <a:pt x="127" y="157"/>
                          <a:pt x="106" y="181"/>
                          <a:pt x="68" y="193"/>
                        </a:cubicBezTo>
                        <a:cubicBezTo>
                          <a:pt x="78" y="179"/>
                          <a:pt x="94" y="171"/>
                          <a:pt x="112" y="165"/>
                        </a:cubicBezTo>
                        <a:cubicBezTo>
                          <a:pt x="76" y="150"/>
                          <a:pt x="57" y="201"/>
                          <a:pt x="16" y="181"/>
                        </a:cubicBezTo>
                        <a:cubicBezTo>
                          <a:pt x="37" y="176"/>
                          <a:pt x="61" y="173"/>
                          <a:pt x="76" y="161"/>
                        </a:cubicBezTo>
                        <a:cubicBezTo>
                          <a:pt x="65" y="155"/>
                          <a:pt x="53" y="150"/>
                          <a:pt x="44" y="141"/>
                        </a:cubicBezTo>
                        <a:cubicBezTo>
                          <a:pt x="74" y="158"/>
                          <a:pt x="127" y="147"/>
                          <a:pt x="168" y="153"/>
                        </a:cubicBezTo>
                        <a:cubicBezTo>
                          <a:pt x="232" y="163"/>
                          <a:pt x="258" y="224"/>
                          <a:pt x="304" y="245"/>
                        </a:cubicBezTo>
                        <a:cubicBezTo>
                          <a:pt x="427" y="231"/>
                          <a:pt x="372" y="66"/>
                          <a:pt x="284" y="53"/>
                        </a:cubicBezTo>
                        <a:cubicBezTo>
                          <a:pt x="348" y="54"/>
                          <a:pt x="410" y="139"/>
                          <a:pt x="376" y="213"/>
                        </a:cubicBezTo>
                        <a:cubicBezTo>
                          <a:pt x="433" y="162"/>
                          <a:pt x="520" y="133"/>
                          <a:pt x="554" y="0"/>
                        </a:cubicBezTo>
                        <a:cubicBezTo>
                          <a:pt x="562" y="7"/>
                          <a:pt x="555" y="49"/>
                          <a:pt x="548" y="55"/>
                        </a:cubicBezTo>
                        <a:cubicBezTo>
                          <a:pt x="557" y="58"/>
                          <a:pt x="568" y="52"/>
                          <a:pt x="576" y="65"/>
                        </a:cubicBezTo>
                        <a:cubicBezTo>
                          <a:pt x="541" y="51"/>
                          <a:pt x="523" y="106"/>
                          <a:pt x="500" y="129"/>
                        </a:cubicBezTo>
                        <a:cubicBezTo>
                          <a:pt x="531" y="120"/>
                          <a:pt x="561" y="130"/>
                          <a:pt x="584" y="141"/>
                        </a:cubicBezTo>
                        <a:lnTo>
                          <a:pt x="619" y="167"/>
                        </a:lnTo>
                        <a:close/>
                      </a:path>
                    </a:pathLst>
                  </a:custGeom>
                  <a:solidFill>
                    <a:srgbClr val="23FF49"/>
                  </a:solidFill>
                  <a:ln w="6350" cap="flat">
                    <a:solidFill>
                      <a:srgbClr val="FF66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188" name="Oval 1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53" y="1834"/>
                    <a:ext cx="182" cy="193"/>
                  </a:xfrm>
                  <a:prstGeom prst="ellipse">
                    <a:avLst/>
                  </a:prstGeom>
                  <a:solidFill>
                    <a:srgbClr val="99CCFF"/>
                  </a:solidFill>
                  <a:ln w="6350">
                    <a:solidFill>
                      <a:srgbClr val="3366FF"/>
                    </a:solidFill>
                    <a:round/>
                    <a:headEnd/>
                    <a:tailEnd/>
                  </a:ln>
                  <a:effectLst/>
                  <a:extLs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</p:grpSp>
        <p:sp>
          <p:nvSpPr>
            <p:cNvPr id="26" name="TextBox 25"/>
            <p:cNvSpPr txBox="1"/>
            <p:nvPr/>
          </p:nvSpPr>
          <p:spPr>
            <a:xfrm>
              <a:off x="4149036" y="3003571"/>
              <a:ext cx="795338" cy="30797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1400" dirty="0">
                  <a:solidFill>
                    <a:srgbClr val="000000"/>
                  </a:solidFill>
                </a:rPr>
                <a:t>Mon/mf</a:t>
              </a:r>
            </a:p>
          </p:txBody>
        </p:sp>
        <p:grpSp>
          <p:nvGrpSpPr>
            <p:cNvPr id="28" name="Group 27"/>
            <p:cNvGrpSpPr>
              <a:grpSpLocks/>
            </p:cNvGrpSpPr>
            <p:nvPr/>
          </p:nvGrpSpPr>
          <p:grpSpPr bwMode="auto">
            <a:xfrm>
              <a:off x="4060903" y="2549912"/>
              <a:ext cx="1119188" cy="506413"/>
              <a:chOff x="2412495" y="2541073"/>
              <a:chExt cx="1104230" cy="635001"/>
            </a:xfrm>
          </p:grpSpPr>
          <p:pic>
            <p:nvPicPr>
              <p:cNvPr id="25629" name="Picture 3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12495" y="2576879"/>
                <a:ext cx="1104230" cy="5991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25630" name="Group 41"/>
              <p:cNvGrpSpPr>
                <a:grpSpLocks/>
              </p:cNvGrpSpPr>
              <p:nvPr/>
            </p:nvGrpSpPr>
            <p:grpSpPr bwMode="auto">
              <a:xfrm>
                <a:off x="2569014" y="2541073"/>
                <a:ext cx="695538" cy="629505"/>
                <a:chOff x="4731542" y="2716797"/>
                <a:chExt cx="695538" cy="629505"/>
              </a:xfrm>
            </p:grpSpPr>
            <p:grpSp>
              <p:nvGrpSpPr>
                <p:cNvPr id="25631" name="Group 63"/>
                <p:cNvGrpSpPr>
                  <a:grpSpLocks noChangeAspect="1"/>
                </p:cNvGrpSpPr>
                <p:nvPr/>
              </p:nvGrpSpPr>
              <p:grpSpPr bwMode="auto">
                <a:xfrm>
                  <a:off x="4731542" y="2781023"/>
                  <a:ext cx="207177" cy="207177"/>
                  <a:chOff x="1440" y="720"/>
                  <a:chExt cx="2879" cy="2879"/>
                </a:xfrm>
              </p:grpSpPr>
              <p:sp>
                <p:nvSpPr>
                  <p:cNvPr id="25686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687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100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77" y="2013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1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16" y="1709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2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81" y="1764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3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9" y="1349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4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2" y="1819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5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22" y="1819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6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17" y="1072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7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7" y="1460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8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77" y="1072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09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47" y="1072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10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09" y="1653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11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05" y="1819"/>
                    <a:ext cx="196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12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2" y="1460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13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17" y="1432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114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29" y="1460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632" name="Group 63"/>
                <p:cNvGrpSpPr>
                  <a:grpSpLocks noChangeAspect="1"/>
                </p:cNvGrpSpPr>
                <p:nvPr/>
              </p:nvGrpSpPr>
              <p:grpSpPr bwMode="auto">
                <a:xfrm>
                  <a:off x="5150783" y="2716797"/>
                  <a:ext cx="207177" cy="207177"/>
                  <a:chOff x="1440" y="720"/>
                  <a:chExt cx="2879" cy="2879"/>
                </a:xfrm>
              </p:grpSpPr>
              <p:sp>
                <p:nvSpPr>
                  <p:cNvPr id="25669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670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83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5" y="2020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4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24" y="1716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5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88" y="1771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6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17" y="1356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7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9" y="1826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8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29" y="1826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9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5" y="1080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0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55" y="146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1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5" y="1080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2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55" y="1080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3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17" y="1661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4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12" y="1826"/>
                    <a:ext cx="196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5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9" y="146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6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5" y="1439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97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36" y="146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633" name="Group 63"/>
                <p:cNvGrpSpPr>
                  <a:grpSpLocks noChangeAspect="1"/>
                </p:cNvGrpSpPr>
                <p:nvPr/>
              </p:nvGrpSpPr>
              <p:grpSpPr bwMode="auto">
                <a:xfrm>
                  <a:off x="5219903" y="3092985"/>
                  <a:ext cx="207177" cy="207177"/>
                  <a:chOff x="1440" y="720"/>
                  <a:chExt cx="2879" cy="2879"/>
                </a:xfrm>
              </p:grpSpPr>
              <p:sp>
                <p:nvSpPr>
                  <p:cNvPr id="25652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653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66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2" y="2021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7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21" y="1716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8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685" y="1772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9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14" y="135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0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6" y="182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1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26" y="182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2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2" y="1080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3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52" y="146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4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2" y="1080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5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52" y="1080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6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14" y="1661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7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09" y="1827"/>
                    <a:ext cx="196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8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56" y="146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79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2" y="1440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80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34" y="1467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  <p:grpSp>
              <p:nvGrpSpPr>
                <p:cNvPr id="25634" name="Group 63"/>
                <p:cNvGrpSpPr>
                  <a:grpSpLocks noChangeAspect="1"/>
                </p:cNvGrpSpPr>
                <p:nvPr/>
              </p:nvGrpSpPr>
              <p:grpSpPr bwMode="auto">
                <a:xfrm>
                  <a:off x="4818503" y="3139125"/>
                  <a:ext cx="207177" cy="207177"/>
                  <a:chOff x="1440" y="720"/>
                  <a:chExt cx="2879" cy="2879"/>
                </a:xfrm>
              </p:grpSpPr>
              <p:sp>
                <p:nvSpPr>
                  <p:cNvPr id="25635" name="Freeform 35"/>
                  <p:cNvSpPr>
                    <a:spLocks noChangeAspect="1"/>
                  </p:cNvSpPr>
                  <p:nvPr/>
                </p:nvSpPr>
                <p:spPr bwMode="auto">
                  <a:xfrm>
                    <a:off x="1440" y="720"/>
                    <a:ext cx="2879" cy="2879"/>
                  </a:xfrm>
                  <a:custGeom>
                    <a:avLst/>
                    <a:gdLst>
                      <a:gd name="T0" fmla="*/ 2147483647 w 187"/>
                      <a:gd name="T1" fmla="*/ 2147483647 h 187"/>
                      <a:gd name="T2" fmla="*/ 2147483647 w 187"/>
                      <a:gd name="T3" fmla="*/ 2147483647 h 187"/>
                      <a:gd name="T4" fmla="*/ 2147483647 w 187"/>
                      <a:gd name="T5" fmla="*/ 2147483647 h 187"/>
                      <a:gd name="T6" fmla="*/ 2147483647 w 187"/>
                      <a:gd name="T7" fmla="*/ 2147483647 h 187"/>
                      <a:gd name="T8" fmla="*/ 2147483647 w 187"/>
                      <a:gd name="T9" fmla="*/ 2147483647 h 187"/>
                      <a:gd name="T10" fmla="*/ 2147483647 w 187"/>
                      <a:gd name="T11" fmla="*/ 2147483647 h 187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187" h="187">
                        <a:moveTo>
                          <a:pt x="13" y="114"/>
                        </a:moveTo>
                        <a:cubicBezTo>
                          <a:pt x="20" y="139"/>
                          <a:pt x="38" y="156"/>
                          <a:pt x="55" y="164"/>
                        </a:cubicBezTo>
                        <a:cubicBezTo>
                          <a:pt x="78" y="175"/>
                          <a:pt x="146" y="187"/>
                          <a:pt x="167" y="123"/>
                        </a:cubicBezTo>
                        <a:cubicBezTo>
                          <a:pt x="187" y="56"/>
                          <a:pt x="143" y="18"/>
                          <a:pt x="119" y="10"/>
                        </a:cubicBezTo>
                        <a:cubicBezTo>
                          <a:pt x="89" y="0"/>
                          <a:pt x="58" y="4"/>
                          <a:pt x="37" y="24"/>
                        </a:cubicBezTo>
                        <a:cubicBezTo>
                          <a:pt x="17" y="42"/>
                          <a:pt x="0" y="68"/>
                          <a:pt x="13" y="114"/>
                        </a:cubicBezTo>
                      </a:path>
                    </a:pathLst>
                  </a:custGeom>
                  <a:solidFill>
                    <a:srgbClr val="CCCCFF"/>
                  </a:solidFill>
                  <a:ln w="9525">
                    <a:solidFill>
                      <a:srgbClr val="CC99FF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25636" name="Freeform 36"/>
                  <p:cNvSpPr>
                    <a:spLocks noChangeAspect="1"/>
                  </p:cNvSpPr>
                  <p:nvPr/>
                </p:nvSpPr>
                <p:spPr bwMode="auto">
                  <a:xfrm>
                    <a:off x="1448" y="1721"/>
                    <a:ext cx="2802" cy="1647"/>
                  </a:xfrm>
                  <a:custGeom>
                    <a:avLst/>
                    <a:gdLst>
                      <a:gd name="T0" fmla="*/ 2147483647 w 364"/>
                      <a:gd name="T1" fmla="*/ 2147483647 h 214"/>
                      <a:gd name="T2" fmla="*/ 2147483647 w 364"/>
                      <a:gd name="T3" fmla="*/ 2147483647 h 214"/>
                      <a:gd name="T4" fmla="*/ 2147483647 w 364"/>
                      <a:gd name="T5" fmla="*/ 2147483647 h 214"/>
                      <a:gd name="T6" fmla="*/ 2147483647 w 364"/>
                      <a:gd name="T7" fmla="*/ 2147483647 h 214"/>
                      <a:gd name="T8" fmla="*/ 2147483647 w 364"/>
                      <a:gd name="T9" fmla="*/ 2147483647 h 21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64" h="214">
                        <a:moveTo>
                          <a:pt x="187" y="210"/>
                        </a:moveTo>
                        <a:cubicBezTo>
                          <a:pt x="307" y="206"/>
                          <a:pt x="364" y="91"/>
                          <a:pt x="324" y="47"/>
                        </a:cubicBezTo>
                        <a:cubicBezTo>
                          <a:pt x="283" y="3"/>
                          <a:pt x="256" y="70"/>
                          <a:pt x="177" y="78"/>
                        </a:cubicBezTo>
                        <a:cubicBezTo>
                          <a:pt x="99" y="86"/>
                          <a:pt x="92" y="0"/>
                          <a:pt x="46" y="48"/>
                        </a:cubicBezTo>
                        <a:cubicBezTo>
                          <a:pt x="0" y="96"/>
                          <a:pt x="67" y="214"/>
                          <a:pt x="187" y="210"/>
                        </a:cubicBezTo>
                        <a:close/>
                      </a:path>
                    </a:pathLst>
                  </a:custGeom>
                  <a:solidFill>
                    <a:srgbClr val="A347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49" name="Oval 4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8" y="2016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0" name="Oval 4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127" y="1711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1" name="Oval 4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778" y="1767"/>
                    <a:ext cx="152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2" name="Oval 4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20" y="1352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3" name="Oval 47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62" y="1822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4" name="Oval 48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932" y="1822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5" name="Oval 49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8" y="1075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6" name="Oval 5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58" y="1462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7" name="Oval 5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388" y="1075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8" name="Oval 5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758" y="1075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59" name="Oval 53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20" y="1656"/>
                    <a:ext cx="174" cy="194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0" name="Oval 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215" y="1822"/>
                    <a:ext cx="196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1" name="Oval 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562" y="1462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2" name="Oval 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128" y="1435"/>
                    <a:ext cx="174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  <p:sp>
                <p:nvSpPr>
                  <p:cNvPr id="63" name="Oval 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2061" y="1462"/>
                    <a:ext cx="152" cy="166"/>
                  </a:xfrm>
                  <a:prstGeom prst="ellipse">
                    <a:avLst/>
                  </a:prstGeom>
                  <a:solidFill>
                    <a:srgbClr val="333333"/>
                  </a:solidFill>
                  <a:ln>
                    <a:noFill/>
                  </a:ln>
                  <a:effectLst/>
                  <a:extLst>
                    <a:ext uri="{91240B29-F687-4f45-9708-019B960494DF}">
                      <a14:hiddenLine xmlns:a14="http://schemas.microsoft.com/office/drawing/2010/main" xmlns="" w="9525">
                        <a:solidFill>
                          <a:schemeClr val="tx1"/>
                        </a:solidFill>
                        <a:round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 xmlns="">
                        <a:effectLst>
                          <a:outerShdw blurRad="63500" dist="38099" dir="2700000" algn="ctr" rotWithShape="0">
                            <a:schemeClr val="bg2">
                              <a:alpha val="74998"/>
                            </a:schemeClr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/>
                  <a:p>
                    <a:pPr>
                      <a:defRPr/>
                    </a:pPr>
                    <a:endParaRPr lang="en-US">
                      <a:solidFill>
                        <a:srgbClr val="000000"/>
                      </a:solidFill>
                    </a:endParaRPr>
                  </a:p>
                </p:txBody>
              </p:sp>
            </p:grpSp>
          </p:grpSp>
        </p:grpSp>
        <p:sp>
          <p:nvSpPr>
            <p:cNvPr id="396" name="TextBox 395"/>
            <p:cNvSpPr txBox="1"/>
            <p:nvPr/>
          </p:nvSpPr>
          <p:spPr>
            <a:xfrm>
              <a:off x="5593556" y="3017338"/>
              <a:ext cx="1742978" cy="30777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1400" dirty="0" smtClean="0">
                  <a:solidFill>
                    <a:srgbClr val="000000"/>
                  </a:solidFill>
                </a:rPr>
                <a:t>Mon/cancer cell lines</a:t>
              </a:r>
              <a:endParaRPr lang="en-US" sz="1400" dirty="0">
                <a:solidFill>
                  <a:srgbClr val="000000"/>
                </a:solidFill>
              </a:endParaRPr>
            </a:p>
          </p:txBody>
        </p:sp>
        <p:pic>
          <p:nvPicPr>
            <p:cNvPr id="388" name="Picture 3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24201" y="914400"/>
              <a:ext cx="1119187" cy="477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Rectangle 1"/>
            <p:cNvSpPr>
              <a:spLocks noChangeArrowheads="1"/>
            </p:cNvSpPr>
            <p:nvPr/>
          </p:nvSpPr>
          <p:spPr bwMode="auto">
            <a:xfrm>
              <a:off x="3352800" y="1447800"/>
              <a:ext cx="444802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b="1" dirty="0">
                  <a:solidFill>
                    <a:srgbClr val="000000"/>
                  </a:solidFill>
                </a:rPr>
                <a:t>mf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924800" y="1447800"/>
              <a:ext cx="17091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000000"/>
                  </a:solidFill>
                </a:rPr>
                <a:t>Cancer cell lines</a:t>
              </a:r>
              <a:endParaRPr lang="en-US" b="1" dirty="0">
                <a:solidFill>
                  <a:srgbClr val="000000"/>
                </a:solidFill>
              </a:endParaRPr>
            </a:p>
          </p:txBody>
        </p:sp>
        <p:pic>
          <p:nvPicPr>
            <p:cNvPr id="350" name="Picture 34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2105" y="1265768"/>
              <a:ext cx="2254496" cy="5327816"/>
            </a:xfrm>
            <a:prstGeom prst="rect">
              <a:avLst/>
            </a:prstGeom>
          </p:spPr>
        </p:pic>
        <p:pic>
          <p:nvPicPr>
            <p:cNvPr id="351" name="Picture 35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25941" y="4447535"/>
              <a:ext cx="5481125" cy="1711823"/>
            </a:xfrm>
            <a:prstGeom prst="rect">
              <a:avLst/>
            </a:prstGeom>
          </p:spPr>
        </p:pic>
        <p:cxnSp>
          <p:nvCxnSpPr>
            <p:cNvPr id="368" name="Straight Arrow Connector 367"/>
            <p:cNvCxnSpPr/>
            <p:nvPr/>
          </p:nvCxnSpPr>
          <p:spPr>
            <a:xfrm>
              <a:off x="5396454" y="3895362"/>
              <a:ext cx="13184" cy="524971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9" name="Straight Arrow Connector 368"/>
            <p:cNvCxnSpPr/>
            <p:nvPr/>
          </p:nvCxnSpPr>
          <p:spPr>
            <a:xfrm flipH="1">
              <a:off x="3824315" y="3550457"/>
              <a:ext cx="799202" cy="2858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229371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7</Words>
  <Application>Microsoft Macintosh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17-09-26T22:56:20Z</dcterms:created>
  <dcterms:modified xsi:type="dcterms:W3CDTF">2017-09-26T23:03:49Z</dcterms:modified>
</cp:coreProperties>
</file>